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4" r:id="rId2"/>
  </p:sldIdLst>
  <p:sldSz cx="12192000" cy="6858000"/>
  <p:notesSz cx="6802438" cy="99345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98" autoAdjust="0"/>
    <p:restoredTop sz="94921" autoAdjust="0"/>
  </p:normalViewPr>
  <p:slideViewPr>
    <p:cSldViewPr snapToGrid="0">
      <p:cViewPr varScale="1">
        <p:scale>
          <a:sx n="89" d="100"/>
          <a:sy n="89" d="100"/>
        </p:scale>
        <p:origin x="456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4330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8158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99697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8776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6915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1980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3883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2841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46306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29496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794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CC400-6E8B-488F-B0D8-EF4C01DDC8E2}" type="datetimeFigureOut">
              <a:rPr lang="en-IN" smtClean="0"/>
              <a:t>23-12-2019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06E18-C386-4AF2-ACEC-D4ABCF2B18F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017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TextBox 130"/>
          <p:cNvSpPr txBox="1"/>
          <p:nvPr/>
        </p:nvSpPr>
        <p:spPr>
          <a:xfrm>
            <a:off x="4905298" y="220782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5089334" y="245881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5161610" y="247160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4906286" y="234779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4920550" y="240555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4855179" y="232681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4888509" y="228167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4917772" y="2140479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4942283" y="2176905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4972158" y="2128294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875474" y="2176664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4949219" y="209560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 flipV="1">
            <a:off x="6554175" y="1554442"/>
            <a:ext cx="588841" cy="308165"/>
          </a:xfrm>
          <a:prstGeom prst="rect">
            <a:avLst/>
          </a:prstGeom>
        </p:spPr>
      </p:pic>
      <p:sp>
        <p:nvSpPr>
          <p:cNvPr id="222" name="TextBox 221"/>
          <p:cNvSpPr txBox="1"/>
          <p:nvPr/>
        </p:nvSpPr>
        <p:spPr>
          <a:xfrm>
            <a:off x="6082775" y="4020830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251"/>
          <p:cNvSpPr txBox="1"/>
          <p:nvPr/>
        </p:nvSpPr>
        <p:spPr>
          <a:xfrm>
            <a:off x="6083779" y="3985193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6119973" y="3984340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6037501" y="387879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6050555" y="4082471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/>
          <p:cNvSpPr txBox="1"/>
          <p:nvPr/>
        </p:nvSpPr>
        <p:spPr>
          <a:xfrm>
            <a:off x="6048616" y="403225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6030557" y="4057745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6050153" y="3934993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6074961" y="405690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6057652" y="396935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6069813" y="3914083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6040972" y="390646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6008326" y="386554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6056002" y="4000804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TextBox 252"/>
          <p:cNvSpPr txBox="1"/>
          <p:nvPr/>
        </p:nvSpPr>
        <p:spPr>
          <a:xfrm>
            <a:off x="6090150" y="384826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3" name="Straight Connector 382"/>
          <p:cNvCxnSpPr/>
          <p:nvPr/>
        </p:nvCxnSpPr>
        <p:spPr>
          <a:xfrm>
            <a:off x="4548237" y="1944311"/>
            <a:ext cx="1174756" cy="0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8" name="Straight Connector 377"/>
          <p:cNvCxnSpPr/>
          <p:nvPr/>
        </p:nvCxnSpPr>
        <p:spPr>
          <a:xfrm flipV="1">
            <a:off x="4660695" y="3776720"/>
            <a:ext cx="2127831" cy="760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7" name="Trapezoid 376"/>
          <p:cNvSpPr/>
          <p:nvPr/>
        </p:nvSpPr>
        <p:spPr>
          <a:xfrm rot="10800000">
            <a:off x="4665681" y="4291353"/>
            <a:ext cx="2120028" cy="134883"/>
          </a:xfrm>
          <a:prstGeom prst="trapezoid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371" name="Straight Connector 370"/>
          <p:cNvCxnSpPr/>
          <p:nvPr/>
        </p:nvCxnSpPr>
        <p:spPr>
          <a:xfrm>
            <a:off x="4663743" y="4292912"/>
            <a:ext cx="2121967" cy="0"/>
          </a:xfrm>
          <a:prstGeom prst="line">
            <a:avLst/>
          </a:prstGeom>
          <a:ln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Isosceles Triangle 120"/>
          <p:cNvSpPr/>
          <p:nvPr/>
        </p:nvSpPr>
        <p:spPr>
          <a:xfrm rot="9096297">
            <a:off x="5057766" y="1612294"/>
            <a:ext cx="60035" cy="346334"/>
          </a:xfrm>
          <a:prstGeom prst="triangl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9" name="Isosceles Triangle 118"/>
          <p:cNvSpPr/>
          <p:nvPr/>
        </p:nvSpPr>
        <p:spPr>
          <a:xfrm rot="12466337">
            <a:off x="5373542" y="1706991"/>
            <a:ext cx="65411" cy="338827"/>
          </a:xfrm>
          <a:prstGeom prst="triangl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1" name="Oval 50"/>
          <p:cNvSpPr/>
          <p:nvPr/>
        </p:nvSpPr>
        <p:spPr>
          <a:xfrm>
            <a:off x="2623474" y="3773239"/>
            <a:ext cx="575310" cy="584351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" name="Oval 5"/>
          <p:cNvSpPr/>
          <p:nvPr/>
        </p:nvSpPr>
        <p:spPr>
          <a:xfrm>
            <a:off x="2420568" y="2002597"/>
            <a:ext cx="575310" cy="584351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2" name="Oval 11"/>
          <p:cNvSpPr/>
          <p:nvPr/>
        </p:nvSpPr>
        <p:spPr>
          <a:xfrm>
            <a:off x="2600911" y="2103783"/>
            <a:ext cx="219405" cy="230933"/>
          </a:xfrm>
          <a:prstGeom prst="ellips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3" name="Straight Connector 2"/>
          <p:cNvCxnSpPr/>
          <p:nvPr/>
        </p:nvCxnSpPr>
        <p:spPr>
          <a:xfrm>
            <a:off x="2685916" y="3069208"/>
            <a:ext cx="6130052" cy="2315"/>
          </a:xfrm>
          <a:prstGeom prst="line">
            <a:avLst/>
          </a:prstGeom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>
            <a:off x="2703482" y="2741412"/>
            <a:ext cx="1" cy="297186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8801108" y="3063477"/>
            <a:ext cx="0" cy="11331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2546188" y="3136272"/>
            <a:ext cx="3107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720629" y="3131512"/>
            <a:ext cx="398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941819" y="3137106"/>
            <a:ext cx="398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143107" y="3137918"/>
            <a:ext cx="398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365134" y="3138231"/>
            <a:ext cx="398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594182" y="3132318"/>
            <a:ext cx="3980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046825" y="3122948"/>
            <a:ext cx="651401" cy="2858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urs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/>
          <p:cNvCxnSpPr/>
          <p:nvPr/>
        </p:nvCxnSpPr>
        <p:spPr>
          <a:xfrm>
            <a:off x="7566070" y="3060940"/>
            <a:ext cx="0" cy="11331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6340311" y="3060940"/>
            <a:ext cx="0" cy="11331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5136097" y="3064951"/>
            <a:ext cx="0" cy="11331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3919853" y="3064951"/>
            <a:ext cx="0" cy="11331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2701161" y="3064951"/>
            <a:ext cx="0" cy="11331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AutoShape 2" descr="Related image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N"/>
          </a:p>
        </p:txBody>
      </p:sp>
      <p:sp>
        <p:nvSpPr>
          <p:cNvPr id="102" name="TextBox 101"/>
          <p:cNvSpPr txBox="1"/>
          <p:nvPr/>
        </p:nvSpPr>
        <p:spPr>
          <a:xfrm>
            <a:off x="2389844" y="4468389"/>
            <a:ext cx="10309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leaching</a:t>
            </a:r>
            <a:endParaRPr lang="en-IN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4628760" y="4473195"/>
            <a:ext cx="21942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icroinjection (30 hpf)</a:t>
            </a:r>
            <a:endParaRPr lang="en-IN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4455173" y="984997"/>
            <a:ext cx="15316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chorionation </a:t>
            </a:r>
            <a:endParaRPr lang="en-IN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1910675" y="981308"/>
            <a:ext cx="18665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mbryos collected after mating</a:t>
            </a:r>
            <a:endParaRPr lang="en-IN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6427061" y="986543"/>
            <a:ext cx="1459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NA extraction </a:t>
            </a:r>
            <a:endParaRPr lang="en-IN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7763180" y="2405005"/>
            <a:ext cx="890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 hpi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6134574" y="2405005"/>
            <a:ext cx="751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hpi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678834" y="2407920"/>
            <a:ext cx="751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I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hpi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>
            <a:off x="7758231" y="1982439"/>
            <a:ext cx="240537" cy="41812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flipH="1">
            <a:off x="6169968" y="1931357"/>
            <a:ext cx="285310" cy="46920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>
            <a:endCxn id="108" idx="0"/>
          </p:cNvCxnSpPr>
          <p:nvPr/>
        </p:nvCxnSpPr>
        <p:spPr>
          <a:xfrm flipH="1">
            <a:off x="6510291" y="2055454"/>
            <a:ext cx="141920" cy="34955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1816688" y="5163729"/>
            <a:ext cx="8698126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S2. The experimental design is represented schematically. 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Zebrafis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mbryos of AB line were treated with 0.003% bleach (Kao, Japan) to remove germs and raised in sterile E3 medium at 28.5°C. At 24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p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orio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layer was torn off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echorionate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Embryos we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ject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t 3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p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ith variou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mples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cluding LPS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seudomonas 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aeruginosa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Sigma, USA), poly (I:C) (Sigma, US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water </a:t>
            </a:r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(control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rRNA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. col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chicken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zebrafis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Total RNA was extracted from a pool of 8 injected embryos at indicated time points to assess the induction level upon stimulation by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RT: Reverse transcription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I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Oval 1"/>
          <p:cNvSpPr/>
          <p:nvPr/>
        </p:nvSpPr>
        <p:spPr>
          <a:xfrm>
            <a:off x="2568763" y="2153570"/>
            <a:ext cx="275208" cy="277276"/>
          </a:xfrm>
          <a:prstGeom prst="ellipse">
            <a:avLst/>
          </a:prstGeom>
          <a:solidFill>
            <a:schemeClr val="bg2">
              <a:lumMod val="9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9" name="Oval 48"/>
          <p:cNvSpPr/>
          <p:nvPr/>
        </p:nvSpPr>
        <p:spPr>
          <a:xfrm>
            <a:off x="2803817" y="3874425"/>
            <a:ext cx="219405" cy="230933"/>
          </a:xfrm>
          <a:prstGeom prst="ellips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0" name="Oval 49"/>
          <p:cNvSpPr/>
          <p:nvPr/>
        </p:nvSpPr>
        <p:spPr>
          <a:xfrm>
            <a:off x="2771669" y="3924212"/>
            <a:ext cx="275208" cy="277276"/>
          </a:xfrm>
          <a:prstGeom prst="ellipse">
            <a:avLst/>
          </a:prstGeom>
          <a:solidFill>
            <a:schemeClr val="bg2">
              <a:lumMod val="9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9" name="Freeform 18"/>
          <p:cNvSpPr/>
          <p:nvPr/>
        </p:nvSpPr>
        <p:spPr>
          <a:xfrm>
            <a:off x="2499138" y="2128654"/>
            <a:ext cx="18141" cy="34585"/>
          </a:xfrm>
          <a:custGeom>
            <a:avLst/>
            <a:gdLst>
              <a:gd name="connsiteX0" fmla="*/ 186 w 18141"/>
              <a:gd name="connsiteY0" fmla="*/ 536 h 34585"/>
              <a:gd name="connsiteX1" fmla="*/ 8652 w 18141"/>
              <a:gd name="connsiteY1" fmla="*/ 14647 h 34585"/>
              <a:gd name="connsiteX2" fmla="*/ 14297 w 18141"/>
              <a:gd name="connsiteY2" fmla="*/ 23113 h 34585"/>
              <a:gd name="connsiteX3" fmla="*/ 17119 w 18141"/>
              <a:gd name="connsiteY3" fmla="*/ 34402 h 34585"/>
              <a:gd name="connsiteX4" fmla="*/ 186 w 18141"/>
              <a:gd name="connsiteY4" fmla="*/ 536 h 345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8141" h="34585">
                <a:moveTo>
                  <a:pt x="186" y="536"/>
                </a:moveTo>
                <a:cubicBezTo>
                  <a:pt x="-1225" y="-2757"/>
                  <a:pt x="5745" y="9996"/>
                  <a:pt x="8652" y="14647"/>
                </a:cubicBezTo>
                <a:cubicBezTo>
                  <a:pt x="10450" y="17523"/>
                  <a:pt x="12961" y="19995"/>
                  <a:pt x="14297" y="23113"/>
                </a:cubicBezTo>
                <a:cubicBezTo>
                  <a:pt x="15825" y="26678"/>
                  <a:pt x="13650" y="32667"/>
                  <a:pt x="17119" y="34402"/>
                </a:cubicBezTo>
                <a:cubicBezTo>
                  <a:pt x="23009" y="37347"/>
                  <a:pt x="1597" y="3829"/>
                  <a:pt x="186" y="536"/>
                </a:cubicBezTo>
                <a:close/>
              </a:path>
            </a:pathLst>
          </a:custGeom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1" name="Freeform 20"/>
          <p:cNvSpPr/>
          <p:nvPr/>
        </p:nvSpPr>
        <p:spPr>
          <a:xfrm>
            <a:off x="2561412" y="2558167"/>
            <a:ext cx="79023" cy="25400"/>
          </a:xfrm>
          <a:custGeom>
            <a:avLst/>
            <a:gdLst>
              <a:gd name="connsiteX0" fmla="*/ 0 w 79023"/>
              <a:gd name="connsiteY0" fmla="*/ 19756 h 25400"/>
              <a:gd name="connsiteX1" fmla="*/ 14112 w 79023"/>
              <a:gd name="connsiteY1" fmla="*/ 22578 h 25400"/>
              <a:gd name="connsiteX2" fmla="*/ 22578 w 79023"/>
              <a:gd name="connsiteY2" fmla="*/ 25400 h 25400"/>
              <a:gd name="connsiteX3" fmla="*/ 56445 w 79023"/>
              <a:gd name="connsiteY3" fmla="*/ 22578 h 25400"/>
              <a:gd name="connsiteX4" fmla="*/ 73378 w 79023"/>
              <a:gd name="connsiteY4" fmla="*/ 2823 h 25400"/>
              <a:gd name="connsiteX5" fmla="*/ 79023 w 79023"/>
              <a:gd name="connsiteY5" fmla="*/ 0 h 25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79023" h="25400">
                <a:moveTo>
                  <a:pt x="0" y="19756"/>
                </a:moveTo>
                <a:cubicBezTo>
                  <a:pt x="4704" y="20697"/>
                  <a:pt x="9458" y="21415"/>
                  <a:pt x="14112" y="22578"/>
                </a:cubicBezTo>
                <a:cubicBezTo>
                  <a:pt x="16998" y="23299"/>
                  <a:pt x="19603" y="25400"/>
                  <a:pt x="22578" y="25400"/>
                </a:cubicBezTo>
                <a:cubicBezTo>
                  <a:pt x="33906" y="25400"/>
                  <a:pt x="45156" y="23519"/>
                  <a:pt x="56445" y="22578"/>
                </a:cubicBezTo>
                <a:cubicBezTo>
                  <a:pt x="64134" y="-489"/>
                  <a:pt x="55784" y="8688"/>
                  <a:pt x="73378" y="2823"/>
                </a:cubicBezTo>
                <a:cubicBezTo>
                  <a:pt x="75374" y="2158"/>
                  <a:pt x="77141" y="941"/>
                  <a:pt x="79023" y="0"/>
                </a:cubicBezTo>
              </a:path>
            </a:pathLst>
          </a:custGeom>
          <a:noFill/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2" name="Freeform 21"/>
          <p:cNvSpPr/>
          <p:nvPr/>
        </p:nvSpPr>
        <p:spPr>
          <a:xfrm>
            <a:off x="2880324" y="2202567"/>
            <a:ext cx="0" cy="0"/>
          </a:xfrm>
          <a:custGeom>
            <a:avLst/>
            <a:gdLst>
              <a:gd name="connsiteX0" fmla="*/ 0 w 0"/>
              <a:gd name="connsiteY0" fmla="*/ 0 h 0"/>
              <a:gd name="connsiteX1" fmla="*/ 0 w 0"/>
              <a:gd name="connsiteY1" fmla="*/ 0 h 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noFill/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3" name="Freeform 22"/>
          <p:cNvSpPr/>
          <p:nvPr/>
        </p:nvSpPr>
        <p:spPr>
          <a:xfrm>
            <a:off x="2902901" y="2151767"/>
            <a:ext cx="45156" cy="84667"/>
          </a:xfrm>
          <a:custGeom>
            <a:avLst/>
            <a:gdLst>
              <a:gd name="connsiteX0" fmla="*/ 0 w 45156"/>
              <a:gd name="connsiteY0" fmla="*/ 0 h 84667"/>
              <a:gd name="connsiteX1" fmla="*/ 8467 w 45156"/>
              <a:gd name="connsiteY1" fmla="*/ 28223 h 84667"/>
              <a:gd name="connsiteX2" fmla="*/ 16934 w 45156"/>
              <a:gd name="connsiteY2" fmla="*/ 31045 h 84667"/>
              <a:gd name="connsiteX3" fmla="*/ 25400 w 45156"/>
              <a:gd name="connsiteY3" fmla="*/ 36689 h 84667"/>
              <a:gd name="connsiteX4" fmla="*/ 33867 w 45156"/>
              <a:gd name="connsiteY4" fmla="*/ 39511 h 84667"/>
              <a:gd name="connsiteX5" fmla="*/ 39511 w 45156"/>
              <a:gd name="connsiteY5" fmla="*/ 47978 h 84667"/>
              <a:gd name="connsiteX6" fmla="*/ 45156 w 45156"/>
              <a:gd name="connsiteY6" fmla="*/ 84667 h 846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5156" h="84667">
                <a:moveTo>
                  <a:pt x="0" y="0"/>
                </a:moveTo>
                <a:cubicBezTo>
                  <a:pt x="1456" y="11646"/>
                  <a:pt x="-1944" y="21976"/>
                  <a:pt x="8467" y="28223"/>
                </a:cubicBezTo>
                <a:cubicBezTo>
                  <a:pt x="11018" y="29754"/>
                  <a:pt x="14112" y="30104"/>
                  <a:pt x="16934" y="31045"/>
                </a:cubicBezTo>
                <a:cubicBezTo>
                  <a:pt x="19756" y="32926"/>
                  <a:pt x="22366" y="35172"/>
                  <a:pt x="25400" y="36689"/>
                </a:cubicBezTo>
                <a:cubicBezTo>
                  <a:pt x="28061" y="38019"/>
                  <a:pt x="31544" y="37653"/>
                  <a:pt x="33867" y="39511"/>
                </a:cubicBezTo>
                <a:cubicBezTo>
                  <a:pt x="36516" y="41630"/>
                  <a:pt x="37630" y="45156"/>
                  <a:pt x="39511" y="47978"/>
                </a:cubicBezTo>
                <a:cubicBezTo>
                  <a:pt x="42445" y="83171"/>
                  <a:pt x="34324" y="73835"/>
                  <a:pt x="45156" y="84667"/>
                </a:cubicBezTo>
              </a:path>
            </a:pathLst>
          </a:custGeom>
          <a:noFill/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4" name="Freeform 23"/>
          <p:cNvSpPr/>
          <p:nvPr/>
        </p:nvSpPr>
        <p:spPr>
          <a:xfrm>
            <a:off x="2851753" y="2346501"/>
            <a:ext cx="57449" cy="79028"/>
          </a:xfrm>
          <a:custGeom>
            <a:avLst/>
            <a:gdLst>
              <a:gd name="connsiteX0" fmla="*/ 56793 w 57449"/>
              <a:gd name="connsiteY0" fmla="*/ 0 h 79028"/>
              <a:gd name="connsiteX1" fmla="*/ 48326 w 57449"/>
              <a:gd name="connsiteY1" fmla="*/ 53622 h 79028"/>
              <a:gd name="connsiteX2" fmla="*/ 42682 w 57449"/>
              <a:gd name="connsiteY2" fmla="*/ 62089 h 79028"/>
              <a:gd name="connsiteX3" fmla="*/ 31393 w 57449"/>
              <a:gd name="connsiteY3" fmla="*/ 64911 h 79028"/>
              <a:gd name="connsiteX4" fmla="*/ 22926 w 57449"/>
              <a:gd name="connsiteY4" fmla="*/ 67733 h 79028"/>
              <a:gd name="connsiteX5" fmla="*/ 17282 w 57449"/>
              <a:gd name="connsiteY5" fmla="*/ 76200 h 79028"/>
              <a:gd name="connsiteX6" fmla="*/ 348 w 57449"/>
              <a:gd name="connsiteY6" fmla="*/ 76200 h 79028"/>
              <a:gd name="connsiteX7" fmla="*/ 348 w 57449"/>
              <a:gd name="connsiteY7" fmla="*/ 73377 h 79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57449" h="79028">
                <a:moveTo>
                  <a:pt x="56793" y="0"/>
                </a:moveTo>
                <a:cubicBezTo>
                  <a:pt x="52193" y="78213"/>
                  <a:pt x="65568" y="32068"/>
                  <a:pt x="48326" y="53622"/>
                </a:cubicBezTo>
                <a:cubicBezTo>
                  <a:pt x="46207" y="56271"/>
                  <a:pt x="45504" y="60207"/>
                  <a:pt x="42682" y="62089"/>
                </a:cubicBezTo>
                <a:cubicBezTo>
                  <a:pt x="39455" y="64241"/>
                  <a:pt x="35123" y="63846"/>
                  <a:pt x="31393" y="64911"/>
                </a:cubicBezTo>
                <a:cubicBezTo>
                  <a:pt x="28532" y="65728"/>
                  <a:pt x="25748" y="66792"/>
                  <a:pt x="22926" y="67733"/>
                </a:cubicBezTo>
                <a:cubicBezTo>
                  <a:pt x="21045" y="70555"/>
                  <a:pt x="19931" y="74081"/>
                  <a:pt x="17282" y="76200"/>
                </a:cubicBezTo>
                <a:cubicBezTo>
                  <a:pt x="12151" y="80305"/>
                  <a:pt x="5479" y="79621"/>
                  <a:pt x="348" y="76200"/>
                </a:cubicBezTo>
                <a:cubicBezTo>
                  <a:pt x="-435" y="75678"/>
                  <a:pt x="348" y="74318"/>
                  <a:pt x="348" y="73377"/>
                </a:cubicBezTo>
              </a:path>
            </a:pathLst>
          </a:custGeom>
          <a:noFill/>
          <a:ln w="9525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5" name="Freeform 24"/>
          <p:cNvSpPr/>
          <p:nvPr/>
        </p:nvSpPr>
        <p:spPr>
          <a:xfrm>
            <a:off x="2477315" y="2340748"/>
            <a:ext cx="28536" cy="27807"/>
          </a:xfrm>
          <a:custGeom>
            <a:avLst/>
            <a:gdLst>
              <a:gd name="connsiteX0" fmla="*/ 314 w 28536"/>
              <a:gd name="connsiteY0" fmla="*/ 204 h 27807"/>
              <a:gd name="connsiteX1" fmla="*/ 14425 w 28536"/>
              <a:gd name="connsiteY1" fmla="*/ 14316 h 27807"/>
              <a:gd name="connsiteX2" fmla="*/ 28536 w 28536"/>
              <a:gd name="connsiteY2" fmla="*/ 25604 h 27807"/>
              <a:gd name="connsiteX3" fmla="*/ 314 w 28536"/>
              <a:gd name="connsiteY3" fmla="*/ 204 h 2780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536" h="27807">
                <a:moveTo>
                  <a:pt x="314" y="204"/>
                </a:moveTo>
                <a:cubicBezTo>
                  <a:pt x="-2038" y="-1677"/>
                  <a:pt x="9419" y="9935"/>
                  <a:pt x="14425" y="14316"/>
                </a:cubicBezTo>
                <a:cubicBezTo>
                  <a:pt x="42942" y="39269"/>
                  <a:pt x="6499" y="3571"/>
                  <a:pt x="28536" y="25604"/>
                </a:cubicBezTo>
                <a:cubicBezTo>
                  <a:pt x="24822" y="36749"/>
                  <a:pt x="2666" y="2085"/>
                  <a:pt x="314" y="204"/>
                </a:cubicBezTo>
                <a:close/>
              </a:path>
            </a:pathLst>
          </a:custGeom>
          <a:ln w="952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7" name="Freeform 26"/>
          <p:cNvSpPr/>
          <p:nvPr/>
        </p:nvSpPr>
        <p:spPr>
          <a:xfrm>
            <a:off x="2685590" y="2037781"/>
            <a:ext cx="71119" cy="40663"/>
          </a:xfrm>
          <a:custGeom>
            <a:avLst/>
            <a:gdLst>
              <a:gd name="connsiteX0" fmla="*/ 0 w 71119"/>
              <a:gd name="connsiteY0" fmla="*/ 1097 h 40663"/>
              <a:gd name="connsiteX1" fmla="*/ 11289 w 71119"/>
              <a:gd name="connsiteY1" fmla="*/ 15209 h 40663"/>
              <a:gd name="connsiteX2" fmla="*/ 19756 w 71119"/>
              <a:gd name="connsiteY2" fmla="*/ 18031 h 40663"/>
              <a:gd name="connsiteX3" fmla="*/ 28222 w 71119"/>
              <a:gd name="connsiteY3" fmla="*/ 23675 h 40663"/>
              <a:gd name="connsiteX4" fmla="*/ 33867 w 71119"/>
              <a:gd name="connsiteY4" fmla="*/ 18031 h 40663"/>
              <a:gd name="connsiteX5" fmla="*/ 36689 w 71119"/>
              <a:gd name="connsiteY5" fmla="*/ 1097 h 40663"/>
              <a:gd name="connsiteX6" fmla="*/ 53622 w 71119"/>
              <a:gd name="connsiteY6" fmla="*/ 3920 h 40663"/>
              <a:gd name="connsiteX7" fmla="*/ 59267 w 71119"/>
              <a:gd name="connsiteY7" fmla="*/ 12386 h 40663"/>
              <a:gd name="connsiteX8" fmla="*/ 62089 w 71119"/>
              <a:gd name="connsiteY8" fmla="*/ 20853 h 40663"/>
              <a:gd name="connsiteX9" fmla="*/ 67734 w 71119"/>
              <a:gd name="connsiteY9" fmla="*/ 26497 h 40663"/>
              <a:gd name="connsiteX10" fmla="*/ 70556 w 71119"/>
              <a:gd name="connsiteY10" fmla="*/ 37786 h 40663"/>
              <a:gd name="connsiteX11" fmla="*/ 67734 w 71119"/>
              <a:gd name="connsiteY11" fmla="*/ 40609 h 406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1119" h="40663">
                <a:moveTo>
                  <a:pt x="0" y="1097"/>
                </a:moveTo>
                <a:cubicBezTo>
                  <a:pt x="3763" y="5801"/>
                  <a:pt x="6715" y="11289"/>
                  <a:pt x="11289" y="15209"/>
                </a:cubicBezTo>
                <a:cubicBezTo>
                  <a:pt x="13548" y="17145"/>
                  <a:pt x="17095" y="16701"/>
                  <a:pt x="19756" y="18031"/>
                </a:cubicBezTo>
                <a:cubicBezTo>
                  <a:pt x="22790" y="19548"/>
                  <a:pt x="25400" y="21794"/>
                  <a:pt x="28222" y="23675"/>
                </a:cubicBezTo>
                <a:cubicBezTo>
                  <a:pt x="30104" y="21794"/>
                  <a:pt x="32933" y="20522"/>
                  <a:pt x="33867" y="18031"/>
                </a:cubicBezTo>
                <a:cubicBezTo>
                  <a:pt x="35876" y="12673"/>
                  <a:pt x="32032" y="4423"/>
                  <a:pt x="36689" y="1097"/>
                </a:cubicBezTo>
                <a:cubicBezTo>
                  <a:pt x="41345" y="-2229"/>
                  <a:pt x="47978" y="2979"/>
                  <a:pt x="53622" y="3920"/>
                </a:cubicBezTo>
                <a:cubicBezTo>
                  <a:pt x="55504" y="6742"/>
                  <a:pt x="57750" y="9352"/>
                  <a:pt x="59267" y="12386"/>
                </a:cubicBezTo>
                <a:cubicBezTo>
                  <a:pt x="60598" y="15047"/>
                  <a:pt x="60558" y="18302"/>
                  <a:pt x="62089" y="20853"/>
                </a:cubicBezTo>
                <a:cubicBezTo>
                  <a:pt x="63458" y="23135"/>
                  <a:pt x="65852" y="24616"/>
                  <a:pt x="67734" y="26497"/>
                </a:cubicBezTo>
                <a:cubicBezTo>
                  <a:pt x="68675" y="30260"/>
                  <a:pt x="72552" y="34460"/>
                  <a:pt x="70556" y="37786"/>
                </a:cubicBezTo>
                <a:cubicBezTo>
                  <a:pt x="68451" y="41294"/>
                  <a:pt x="46713" y="40609"/>
                  <a:pt x="67734" y="40609"/>
                </a:cubicBez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9" name="Freeform 58"/>
          <p:cNvSpPr/>
          <p:nvPr/>
        </p:nvSpPr>
        <p:spPr>
          <a:xfrm>
            <a:off x="2922659" y="2424423"/>
            <a:ext cx="71119" cy="40663"/>
          </a:xfrm>
          <a:custGeom>
            <a:avLst/>
            <a:gdLst>
              <a:gd name="connsiteX0" fmla="*/ 0 w 71119"/>
              <a:gd name="connsiteY0" fmla="*/ 1097 h 40663"/>
              <a:gd name="connsiteX1" fmla="*/ 11289 w 71119"/>
              <a:gd name="connsiteY1" fmla="*/ 15209 h 40663"/>
              <a:gd name="connsiteX2" fmla="*/ 19756 w 71119"/>
              <a:gd name="connsiteY2" fmla="*/ 18031 h 40663"/>
              <a:gd name="connsiteX3" fmla="*/ 28222 w 71119"/>
              <a:gd name="connsiteY3" fmla="*/ 23675 h 40663"/>
              <a:gd name="connsiteX4" fmla="*/ 33867 w 71119"/>
              <a:gd name="connsiteY4" fmla="*/ 18031 h 40663"/>
              <a:gd name="connsiteX5" fmla="*/ 36689 w 71119"/>
              <a:gd name="connsiteY5" fmla="*/ 1097 h 40663"/>
              <a:gd name="connsiteX6" fmla="*/ 53622 w 71119"/>
              <a:gd name="connsiteY6" fmla="*/ 3920 h 40663"/>
              <a:gd name="connsiteX7" fmla="*/ 59267 w 71119"/>
              <a:gd name="connsiteY7" fmla="*/ 12386 h 40663"/>
              <a:gd name="connsiteX8" fmla="*/ 62089 w 71119"/>
              <a:gd name="connsiteY8" fmla="*/ 20853 h 40663"/>
              <a:gd name="connsiteX9" fmla="*/ 67734 w 71119"/>
              <a:gd name="connsiteY9" fmla="*/ 26497 h 40663"/>
              <a:gd name="connsiteX10" fmla="*/ 70556 w 71119"/>
              <a:gd name="connsiteY10" fmla="*/ 37786 h 40663"/>
              <a:gd name="connsiteX11" fmla="*/ 67734 w 71119"/>
              <a:gd name="connsiteY11" fmla="*/ 40609 h 406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1119" h="40663">
                <a:moveTo>
                  <a:pt x="0" y="1097"/>
                </a:moveTo>
                <a:cubicBezTo>
                  <a:pt x="3763" y="5801"/>
                  <a:pt x="6715" y="11289"/>
                  <a:pt x="11289" y="15209"/>
                </a:cubicBezTo>
                <a:cubicBezTo>
                  <a:pt x="13548" y="17145"/>
                  <a:pt x="17095" y="16701"/>
                  <a:pt x="19756" y="18031"/>
                </a:cubicBezTo>
                <a:cubicBezTo>
                  <a:pt x="22790" y="19548"/>
                  <a:pt x="25400" y="21794"/>
                  <a:pt x="28222" y="23675"/>
                </a:cubicBezTo>
                <a:cubicBezTo>
                  <a:pt x="30104" y="21794"/>
                  <a:pt x="32933" y="20522"/>
                  <a:pt x="33867" y="18031"/>
                </a:cubicBezTo>
                <a:cubicBezTo>
                  <a:pt x="35876" y="12673"/>
                  <a:pt x="32032" y="4423"/>
                  <a:pt x="36689" y="1097"/>
                </a:cubicBezTo>
                <a:cubicBezTo>
                  <a:pt x="41345" y="-2229"/>
                  <a:pt x="47978" y="2979"/>
                  <a:pt x="53622" y="3920"/>
                </a:cubicBezTo>
                <a:cubicBezTo>
                  <a:pt x="55504" y="6742"/>
                  <a:pt x="57750" y="9352"/>
                  <a:pt x="59267" y="12386"/>
                </a:cubicBezTo>
                <a:cubicBezTo>
                  <a:pt x="60598" y="15047"/>
                  <a:pt x="60558" y="18302"/>
                  <a:pt x="62089" y="20853"/>
                </a:cubicBezTo>
                <a:cubicBezTo>
                  <a:pt x="63458" y="23135"/>
                  <a:pt x="65852" y="24616"/>
                  <a:pt x="67734" y="26497"/>
                </a:cubicBezTo>
                <a:cubicBezTo>
                  <a:pt x="68675" y="30260"/>
                  <a:pt x="72552" y="34460"/>
                  <a:pt x="70556" y="37786"/>
                </a:cubicBezTo>
                <a:cubicBezTo>
                  <a:pt x="68451" y="41294"/>
                  <a:pt x="46713" y="40609"/>
                  <a:pt x="67734" y="40609"/>
                </a:cubicBez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0" name="Freeform 59"/>
          <p:cNvSpPr/>
          <p:nvPr/>
        </p:nvSpPr>
        <p:spPr>
          <a:xfrm>
            <a:off x="2406196" y="2190181"/>
            <a:ext cx="71119" cy="40663"/>
          </a:xfrm>
          <a:custGeom>
            <a:avLst/>
            <a:gdLst>
              <a:gd name="connsiteX0" fmla="*/ 0 w 71119"/>
              <a:gd name="connsiteY0" fmla="*/ 1097 h 40663"/>
              <a:gd name="connsiteX1" fmla="*/ 11289 w 71119"/>
              <a:gd name="connsiteY1" fmla="*/ 15209 h 40663"/>
              <a:gd name="connsiteX2" fmla="*/ 19756 w 71119"/>
              <a:gd name="connsiteY2" fmla="*/ 18031 h 40663"/>
              <a:gd name="connsiteX3" fmla="*/ 28222 w 71119"/>
              <a:gd name="connsiteY3" fmla="*/ 23675 h 40663"/>
              <a:gd name="connsiteX4" fmla="*/ 33867 w 71119"/>
              <a:gd name="connsiteY4" fmla="*/ 18031 h 40663"/>
              <a:gd name="connsiteX5" fmla="*/ 36689 w 71119"/>
              <a:gd name="connsiteY5" fmla="*/ 1097 h 40663"/>
              <a:gd name="connsiteX6" fmla="*/ 53622 w 71119"/>
              <a:gd name="connsiteY6" fmla="*/ 3920 h 40663"/>
              <a:gd name="connsiteX7" fmla="*/ 59267 w 71119"/>
              <a:gd name="connsiteY7" fmla="*/ 12386 h 40663"/>
              <a:gd name="connsiteX8" fmla="*/ 62089 w 71119"/>
              <a:gd name="connsiteY8" fmla="*/ 20853 h 40663"/>
              <a:gd name="connsiteX9" fmla="*/ 67734 w 71119"/>
              <a:gd name="connsiteY9" fmla="*/ 26497 h 40663"/>
              <a:gd name="connsiteX10" fmla="*/ 70556 w 71119"/>
              <a:gd name="connsiteY10" fmla="*/ 37786 h 40663"/>
              <a:gd name="connsiteX11" fmla="*/ 67734 w 71119"/>
              <a:gd name="connsiteY11" fmla="*/ 40609 h 406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1119" h="40663">
                <a:moveTo>
                  <a:pt x="0" y="1097"/>
                </a:moveTo>
                <a:cubicBezTo>
                  <a:pt x="3763" y="5801"/>
                  <a:pt x="6715" y="11289"/>
                  <a:pt x="11289" y="15209"/>
                </a:cubicBezTo>
                <a:cubicBezTo>
                  <a:pt x="13548" y="17145"/>
                  <a:pt x="17095" y="16701"/>
                  <a:pt x="19756" y="18031"/>
                </a:cubicBezTo>
                <a:cubicBezTo>
                  <a:pt x="22790" y="19548"/>
                  <a:pt x="25400" y="21794"/>
                  <a:pt x="28222" y="23675"/>
                </a:cubicBezTo>
                <a:cubicBezTo>
                  <a:pt x="30104" y="21794"/>
                  <a:pt x="32933" y="20522"/>
                  <a:pt x="33867" y="18031"/>
                </a:cubicBezTo>
                <a:cubicBezTo>
                  <a:pt x="35876" y="12673"/>
                  <a:pt x="32032" y="4423"/>
                  <a:pt x="36689" y="1097"/>
                </a:cubicBezTo>
                <a:cubicBezTo>
                  <a:pt x="41345" y="-2229"/>
                  <a:pt x="47978" y="2979"/>
                  <a:pt x="53622" y="3920"/>
                </a:cubicBezTo>
                <a:cubicBezTo>
                  <a:pt x="55504" y="6742"/>
                  <a:pt x="57750" y="9352"/>
                  <a:pt x="59267" y="12386"/>
                </a:cubicBezTo>
                <a:cubicBezTo>
                  <a:pt x="60598" y="15047"/>
                  <a:pt x="60558" y="18302"/>
                  <a:pt x="62089" y="20853"/>
                </a:cubicBezTo>
                <a:cubicBezTo>
                  <a:pt x="63458" y="23135"/>
                  <a:pt x="65852" y="24616"/>
                  <a:pt x="67734" y="26497"/>
                </a:cubicBezTo>
                <a:cubicBezTo>
                  <a:pt x="68675" y="30260"/>
                  <a:pt x="72552" y="34460"/>
                  <a:pt x="70556" y="37786"/>
                </a:cubicBezTo>
                <a:cubicBezTo>
                  <a:pt x="68451" y="41294"/>
                  <a:pt x="46713" y="40609"/>
                  <a:pt x="67734" y="40609"/>
                </a:cubicBez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1" name="Freeform 60"/>
          <p:cNvSpPr/>
          <p:nvPr/>
        </p:nvSpPr>
        <p:spPr>
          <a:xfrm>
            <a:off x="2820737" y="2493055"/>
            <a:ext cx="28536" cy="27807"/>
          </a:xfrm>
          <a:custGeom>
            <a:avLst/>
            <a:gdLst>
              <a:gd name="connsiteX0" fmla="*/ 314 w 28536"/>
              <a:gd name="connsiteY0" fmla="*/ 204 h 27807"/>
              <a:gd name="connsiteX1" fmla="*/ 14425 w 28536"/>
              <a:gd name="connsiteY1" fmla="*/ 14316 h 27807"/>
              <a:gd name="connsiteX2" fmla="*/ 28536 w 28536"/>
              <a:gd name="connsiteY2" fmla="*/ 25604 h 27807"/>
              <a:gd name="connsiteX3" fmla="*/ 314 w 28536"/>
              <a:gd name="connsiteY3" fmla="*/ 204 h 2780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536" h="27807">
                <a:moveTo>
                  <a:pt x="314" y="204"/>
                </a:moveTo>
                <a:cubicBezTo>
                  <a:pt x="-2038" y="-1677"/>
                  <a:pt x="9419" y="9935"/>
                  <a:pt x="14425" y="14316"/>
                </a:cubicBezTo>
                <a:cubicBezTo>
                  <a:pt x="42942" y="39269"/>
                  <a:pt x="6499" y="3571"/>
                  <a:pt x="28536" y="25604"/>
                </a:cubicBezTo>
                <a:cubicBezTo>
                  <a:pt x="24822" y="36749"/>
                  <a:pt x="2666" y="2085"/>
                  <a:pt x="314" y="204"/>
                </a:cubicBezTo>
                <a:close/>
              </a:path>
            </a:pathLst>
          </a:custGeom>
          <a:ln w="952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3" name="Freeform 62"/>
          <p:cNvSpPr/>
          <p:nvPr/>
        </p:nvSpPr>
        <p:spPr>
          <a:xfrm>
            <a:off x="2761789" y="2524297"/>
            <a:ext cx="45156" cy="84667"/>
          </a:xfrm>
          <a:custGeom>
            <a:avLst/>
            <a:gdLst>
              <a:gd name="connsiteX0" fmla="*/ 0 w 45156"/>
              <a:gd name="connsiteY0" fmla="*/ 0 h 84667"/>
              <a:gd name="connsiteX1" fmla="*/ 8467 w 45156"/>
              <a:gd name="connsiteY1" fmla="*/ 28223 h 84667"/>
              <a:gd name="connsiteX2" fmla="*/ 16934 w 45156"/>
              <a:gd name="connsiteY2" fmla="*/ 31045 h 84667"/>
              <a:gd name="connsiteX3" fmla="*/ 25400 w 45156"/>
              <a:gd name="connsiteY3" fmla="*/ 36689 h 84667"/>
              <a:gd name="connsiteX4" fmla="*/ 33867 w 45156"/>
              <a:gd name="connsiteY4" fmla="*/ 39511 h 84667"/>
              <a:gd name="connsiteX5" fmla="*/ 39511 w 45156"/>
              <a:gd name="connsiteY5" fmla="*/ 47978 h 84667"/>
              <a:gd name="connsiteX6" fmla="*/ 45156 w 45156"/>
              <a:gd name="connsiteY6" fmla="*/ 84667 h 846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5156" h="84667">
                <a:moveTo>
                  <a:pt x="0" y="0"/>
                </a:moveTo>
                <a:cubicBezTo>
                  <a:pt x="1456" y="11646"/>
                  <a:pt x="-1944" y="21976"/>
                  <a:pt x="8467" y="28223"/>
                </a:cubicBezTo>
                <a:cubicBezTo>
                  <a:pt x="11018" y="29754"/>
                  <a:pt x="14112" y="30104"/>
                  <a:pt x="16934" y="31045"/>
                </a:cubicBezTo>
                <a:cubicBezTo>
                  <a:pt x="19756" y="32926"/>
                  <a:pt x="22366" y="35172"/>
                  <a:pt x="25400" y="36689"/>
                </a:cubicBezTo>
                <a:cubicBezTo>
                  <a:pt x="28061" y="38019"/>
                  <a:pt x="31544" y="37653"/>
                  <a:pt x="33867" y="39511"/>
                </a:cubicBezTo>
                <a:cubicBezTo>
                  <a:pt x="36516" y="41630"/>
                  <a:pt x="37630" y="45156"/>
                  <a:pt x="39511" y="47978"/>
                </a:cubicBezTo>
                <a:cubicBezTo>
                  <a:pt x="42445" y="83171"/>
                  <a:pt x="34324" y="73835"/>
                  <a:pt x="45156" y="84667"/>
                </a:cubicBezTo>
              </a:path>
            </a:pathLst>
          </a:custGeom>
          <a:noFill/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4" name="Freeform 63"/>
          <p:cNvSpPr/>
          <p:nvPr/>
        </p:nvSpPr>
        <p:spPr>
          <a:xfrm>
            <a:off x="2578355" y="1982439"/>
            <a:ext cx="45156" cy="84667"/>
          </a:xfrm>
          <a:custGeom>
            <a:avLst/>
            <a:gdLst>
              <a:gd name="connsiteX0" fmla="*/ 0 w 45156"/>
              <a:gd name="connsiteY0" fmla="*/ 0 h 84667"/>
              <a:gd name="connsiteX1" fmla="*/ 8467 w 45156"/>
              <a:gd name="connsiteY1" fmla="*/ 28223 h 84667"/>
              <a:gd name="connsiteX2" fmla="*/ 16934 w 45156"/>
              <a:gd name="connsiteY2" fmla="*/ 31045 h 84667"/>
              <a:gd name="connsiteX3" fmla="*/ 25400 w 45156"/>
              <a:gd name="connsiteY3" fmla="*/ 36689 h 84667"/>
              <a:gd name="connsiteX4" fmla="*/ 33867 w 45156"/>
              <a:gd name="connsiteY4" fmla="*/ 39511 h 84667"/>
              <a:gd name="connsiteX5" fmla="*/ 39511 w 45156"/>
              <a:gd name="connsiteY5" fmla="*/ 47978 h 84667"/>
              <a:gd name="connsiteX6" fmla="*/ 45156 w 45156"/>
              <a:gd name="connsiteY6" fmla="*/ 84667 h 846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5156" h="84667">
                <a:moveTo>
                  <a:pt x="0" y="0"/>
                </a:moveTo>
                <a:cubicBezTo>
                  <a:pt x="1456" y="11646"/>
                  <a:pt x="-1944" y="21976"/>
                  <a:pt x="8467" y="28223"/>
                </a:cubicBezTo>
                <a:cubicBezTo>
                  <a:pt x="11018" y="29754"/>
                  <a:pt x="14112" y="30104"/>
                  <a:pt x="16934" y="31045"/>
                </a:cubicBezTo>
                <a:cubicBezTo>
                  <a:pt x="19756" y="32926"/>
                  <a:pt x="22366" y="35172"/>
                  <a:pt x="25400" y="36689"/>
                </a:cubicBezTo>
                <a:cubicBezTo>
                  <a:pt x="28061" y="38019"/>
                  <a:pt x="31544" y="37653"/>
                  <a:pt x="33867" y="39511"/>
                </a:cubicBezTo>
                <a:cubicBezTo>
                  <a:pt x="36516" y="41630"/>
                  <a:pt x="37630" y="45156"/>
                  <a:pt x="39511" y="47978"/>
                </a:cubicBezTo>
                <a:cubicBezTo>
                  <a:pt x="42445" y="83171"/>
                  <a:pt x="34324" y="73835"/>
                  <a:pt x="45156" y="84667"/>
                </a:cubicBezTo>
              </a:path>
            </a:pathLst>
          </a:custGeom>
          <a:noFill/>
          <a:ln w="952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5" name="Freeform 64"/>
          <p:cNvSpPr/>
          <p:nvPr/>
        </p:nvSpPr>
        <p:spPr>
          <a:xfrm>
            <a:off x="2628233" y="2482118"/>
            <a:ext cx="71119" cy="40663"/>
          </a:xfrm>
          <a:custGeom>
            <a:avLst/>
            <a:gdLst>
              <a:gd name="connsiteX0" fmla="*/ 0 w 71119"/>
              <a:gd name="connsiteY0" fmla="*/ 1097 h 40663"/>
              <a:gd name="connsiteX1" fmla="*/ 11289 w 71119"/>
              <a:gd name="connsiteY1" fmla="*/ 15209 h 40663"/>
              <a:gd name="connsiteX2" fmla="*/ 19756 w 71119"/>
              <a:gd name="connsiteY2" fmla="*/ 18031 h 40663"/>
              <a:gd name="connsiteX3" fmla="*/ 28222 w 71119"/>
              <a:gd name="connsiteY3" fmla="*/ 23675 h 40663"/>
              <a:gd name="connsiteX4" fmla="*/ 33867 w 71119"/>
              <a:gd name="connsiteY4" fmla="*/ 18031 h 40663"/>
              <a:gd name="connsiteX5" fmla="*/ 36689 w 71119"/>
              <a:gd name="connsiteY5" fmla="*/ 1097 h 40663"/>
              <a:gd name="connsiteX6" fmla="*/ 53622 w 71119"/>
              <a:gd name="connsiteY6" fmla="*/ 3920 h 40663"/>
              <a:gd name="connsiteX7" fmla="*/ 59267 w 71119"/>
              <a:gd name="connsiteY7" fmla="*/ 12386 h 40663"/>
              <a:gd name="connsiteX8" fmla="*/ 62089 w 71119"/>
              <a:gd name="connsiteY8" fmla="*/ 20853 h 40663"/>
              <a:gd name="connsiteX9" fmla="*/ 67734 w 71119"/>
              <a:gd name="connsiteY9" fmla="*/ 26497 h 40663"/>
              <a:gd name="connsiteX10" fmla="*/ 70556 w 71119"/>
              <a:gd name="connsiteY10" fmla="*/ 37786 h 40663"/>
              <a:gd name="connsiteX11" fmla="*/ 67734 w 71119"/>
              <a:gd name="connsiteY11" fmla="*/ 40609 h 406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1119" h="40663">
                <a:moveTo>
                  <a:pt x="0" y="1097"/>
                </a:moveTo>
                <a:cubicBezTo>
                  <a:pt x="3763" y="5801"/>
                  <a:pt x="6715" y="11289"/>
                  <a:pt x="11289" y="15209"/>
                </a:cubicBezTo>
                <a:cubicBezTo>
                  <a:pt x="13548" y="17145"/>
                  <a:pt x="17095" y="16701"/>
                  <a:pt x="19756" y="18031"/>
                </a:cubicBezTo>
                <a:cubicBezTo>
                  <a:pt x="22790" y="19548"/>
                  <a:pt x="25400" y="21794"/>
                  <a:pt x="28222" y="23675"/>
                </a:cubicBezTo>
                <a:cubicBezTo>
                  <a:pt x="30104" y="21794"/>
                  <a:pt x="32933" y="20522"/>
                  <a:pt x="33867" y="18031"/>
                </a:cubicBezTo>
                <a:cubicBezTo>
                  <a:pt x="35876" y="12673"/>
                  <a:pt x="32032" y="4423"/>
                  <a:pt x="36689" y="1097"/>
                </a:cubicBezTo>
                <a:cubicBezTo>
                  <a:pt x="41345" y="-2229"/>
                  <a:pt x="47978" y="2979"/>
                  <a:pt x="53622" y="3920"/>
                </a:cubicBezTo>
                <a:cubicBezTo>
                  <a:pt x="55504" y="6742"/>
                  <a:pt x="57750" y="9352"/>
                  <a:pt x="59267" y="12386"/>
                </a:cubicBezTo>
                <a:cubicBezTo>
                  <a:pt x="60598" y="15047"/>
                  <a:pt x="60558" y="18302"/>
                  <a:pt x="62089" y="20853"/>
                </a:cubicBezTo>
                <a:cubicBezTo>
                  <a:pt x="63458" y="23135"/>
                  <a:pt x="65852" y="24616"/>
                  <a:pt x="67734" y="26497"/>
                </a:cubicBezTo>
                <a:cubicBezTo>
                  <a:pt x="68675" y="30260"/>
                  <a:pt x="72552" y="34460"/>
                  <a:pt x="70556" y="37786"/>
                </a:cubicBezTo>
                <a:cubicBezTo>
                  <a:pt x="68451" y="41294"/>
                  <a:pt x="46713" y="40609"/>
                  <a:pt x="67734" y="40609"/>
                </a:cubicBez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6" name="Freeform 65"/>
          <p:cNvSpPr/>
          <p:nvPr/>
        </p:nvSpPr>
        <p:spPr>
          <a:xfrm>
            <a:off x="2504128" y="2381190"/>
            <a:ext cx="57449" cy="79028"/>
          </a:xfrm>
          <a:custGeom>
            <a:avLst/>
            <a:gdLst>
              <a:gd name="connsiteX0" fmla="*/ 56793 w 57449"/>
              <a:gd name="connsiteY0" fmla="*/ 0 h 79028"/>
              <a:gd name="connsiteX1" fmla="*/ 48326 w 57449"/>
              <a:gd name="connsiteY1" fmla="*/ 53622 h 79028"/>
              <a:gd name="connsiteX2" fmla="*/ 42682 w 57449"/>
              <a:gd name="connsiteY2" fmla="*/ 62089 h 79028"/>
              <a:gd name="connsiteX3" fmla="*/ 31393 w 57449"/>
              <a:gd name="connsiteY3" fmla="*/ 64911 h 79028"/>
              <a:gd name="connsiteX4" fmla="*/ 22926 w 57449"/>
              <a:gd name="connsiteY4" fmla="*/ 67733 h 79028"/>
              <a:gd name="connsiteX5" fmla="*/ 17282 w 57449"/>
              <a:gd name="connsiteY5" fmla="*/ 76200 h 79028"/>
              <a:gd name="connsiteX6" fmla="*/ 348 w 57449"/>
              <a:gd name="connsiteY6" fmla="*/ 76200 h 79028"/>
              <a:gd name="connsiteX7" fmla="*/ 348 w 57449"/>
              <a:gd name="connsiteY7" fmla="*/ 73377 h 79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57449" h="79028">
                <a:moveTo>
                  <a:pt x="56793" y="0"/>
                </a:moveTo>
                <a:cubicBezTo>
                  <a:pt x="52193" y="78213"/>
                  <a:pt x="65568" y="32068"/>
                  <a:pt x="48326" y="53622"/>
                </a:cubicBezTo>
                <a:cubicBezTo>
                  <a:pt x="46207" y="56271"/>
                  <a:pt x="45504" y="60207"/>
                  <a:pt x="42682" y="62089"/>
                </a:cubicBezTo>
                <a:cubicBezTo>
                  <a:pt x="39455" y="64241"/>
                  <a:pt x="35123" y="63846"/>
                  <a:pt x="31393" y="64911"/>
                </a:cubicBezTo>
                <a:cubicBezTo>
                  <a:pt x="28532" y="65728"/>
                  <a:pt x="25748" y="66792"/>
                  <a:pt x="22926" y="67733"/>
                </a:cubicBezTo>
                <a:cubicBezTo>
                  <a:pt x="21045" y="70555"/>
                  <a:pt x="19931" y="74081"/>
                  <a:pt x="17282" y="76200"/>
                </a:cubicBezTo>
                <a:cubicBezTo>
                  <a:pt x="12151" y="80305"/>
                  <a:pt x="5479" y="79621"/>
                  <a:pt x="348" y="76200"/>
                </a:cubicBezTo>
                <a:cubicBezTo>
                  <a:pt x="-435" y="75678"/>
                  <a:pt x="348" y="74318"/>
                  <a:pt x="348" y="73377"/>
                </a:cubicBezTo>
              </a:path>
            </a:pathLst>
          </a:custGeom>
          <a:noFill/>
          <a:ln w="9525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7" name="Freeform 66"/>
          <p:cNvSpPr/>
          <p:nvPr/>
        </p:nvSpPr>
        <p:spPr>
          <a:xfrm>
            <a:off x="2857199" y="2002186"/>
            <a:ext cx="57449" cy="79028"/>
          </a:xfrm>
          <a:custGeom>
            <a:avLst/>
            <a:gdLst>
              <a:gd name="connsiteX0" fmla="*/ 56793 w 57449"/>
              <a:gd name="connsiteY0" fmla="*/ 0 h 79028"/>
              <a:gd name="connsiteX1" fmla="*/ 48326 w 57449"/>
              <a:gd name="connsiteY1" fmla="*/ 53622 h 79028"/>
              <a:gd name="connsiteX2" fmla="*/ 42682 w 57449"/>
              <a:gd name="connsiteY2" fmla="*/ 62089 h 79028"/>
              <a:gd name="connsiteX3" fmla="*/ 31393 w 57449"/>
              <a:gd name="connsiteY3" fmla="*/ 64911 h 79028"/>
              <a:gd name="connsiteX4" fmla="*/ 22926 w 57449"/>
              <a:gd name="connsiteY4" fmla="*/ 67733 h 79028"/>
              <a:gd name="connsiteX5" fmla="*/ 17282 w 57449"/>
              <a:gd name="connsiteY5" fmla="*/ 76200 h 79028"/>
              <a:gd name="connsiteX6" fmla="*/ 348 w 57449"/>
              <a:gd name="connsiteY6" fmla="*/ 76200 h 79028"/>
              <a:gd name="connsiteX7" fmla="*/ 348 w 57449"/>
              <a:gd name="connsiteY7" fmla="*/ 73377 h 79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57449" h="79028">
                <a:moveTo>
                  <a:pt x="56793" y="0"/>
                </a:moveTo>
                <a:cubicBezTo>
                  <a:pt x="52193" y="78213"/>
                  <a:pt x="65568" y="32068"/>
                  <a:pt x="48326" y="53622"/>
                </a:cubicBezTo>
                <a:cubicBezTo>
                  <a:pt x="46207" y="56271"/>
                  <a:pt x="45504" y="60207"/>
                  <a:pt x="42682" y="62089"/>
                </a:cubicBezTo>
                <a:cubicBezTo>
                  <a:pt x="39455" y="64241"/>
                  <a:pt x="35123" y="63846"/>
                  <a:pt x="31393" y="64911"/>
                </a:cubicBezTo>
                <a:cubicBezTo>
                  <a:pt x="28532" y="65728"/>
                  <a:pt x="25748" y="66792"/>
                  <a:pt x="22926" y="67733"/>
                </a:cubicBezTo>
                <a:cubicBezTo>
                  <a:pt x="21045" y="70555"/>
                  <a:pt x="19931" y="74081"/>
                  <a:pt x="17282" y="76200"/>
                </a:cubicBezTo>
                <a:cubicBezTo>
                  <a:pt x="12151" y="80305"/>
                  <a:pt x="5479" y="79621"/>
                  <a:pt x="348" y="76200"/>
                </a:cubicBezTo>
                <a:cubicBezTo>
                  <a:pt x="-435" y="75678"/>
                  <a:pt x="348" y="74318"/>
                  <a:pt x="348" y="73377"/>
                </a:cubicBezTo>
              </a:path>
            </a:pathLst>
          </a:custGeom>
          <a:noFill/>
          <a:ln w="9525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8" name="Arc 27"/>
          <p:cNvSpPr/>
          <p:nvPr/>
        </p:nvSpPr>
        <p:spPr>
          <a:xfrm rot="4520776">
            <a:off x="4981569" y="2076733"/>
            <a:ext cx="494500" cy="283435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0" name="Arc 69"/>
          <p:cNvSpPr/>
          <p:nvPr/>
        </p:nvSpPr>
        <p:spPr>
          <a:xfrm rot="3626353">
            <a:off x="4858572" y="2038817"/>
            <a:ext cx="571258" cy="504226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1" name="Arc 70"/>
          <p:cNvSpPr/>
          <p:nvPr/>
        </p:nvSpPr>
        <p:spPr>
          <a:xfrm rot="8556916">
            <a:off x="4866782" y="1987353"/>
            <a:ext cx="533432" cy="593947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2" name="Arc 71"/>
          <p:cNvSpPr/>
          <p:nvPr/>
        </p:nvSpPr>
        <p:spPr>
          <a:xfrm rot="14036497">
            <a:off x="4899293" y="2103199"/>
            <a:ext cx="405996" cy="436437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3" name="Arc 72"/>
          <p:cNvSpPr/>
          <p:nvPr/>
        </p:nvSpPr>
        <p:spPr>
          <a:xfrm rot="19905591">
            <a:off x="4851209" y="2146674"/>
            <a:ext cx="349190" cy="191210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4" name="Arc 73"/>
          <p:cNvSpPr/>
          <p:nvPr/>
        </p:nvSpPr>
        <p:spPr>
          <a:xfrm rot="4991127">
            <a:off x="5012547" y="2085016"/>
            <a:ext cx="165131" cy="171768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5" name="Arc 74"/>
          <p:cNvSpPr/>
          <p:nvPr/>
        </p:nvSpPr>
        <p:spPr>
          <a:xfrm rot="8094364">
            <a:off x="5134535" y="2227597"/>
            <a:ext cx="258137" cy="222579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6" name="Arc 75"/>
          <p:cNvSpPr/>
          <p:nvPr/>
        </p:nvSpPr>
        <p:spPr>
          <a:xfrm rot="17592586">
            <a:off x="4868888" y="2201197"/>
            <a:ext cx="264214" cy="216715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7" name="Arc 76"/>
          <p:cNvSpPr/>
          <p:nvPr/>
        </p:nvSpPr>
        <p:spPr>
          <a:xfrm rot="9570803">
            <a:off x="5139086" y="2304822"/>
            <a:ext cx="267849" cy="159136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9" name="Oval 28"/>
          <p:cNvSpPr/>
          <p:nvPr/>
        </p:nvSpPr>
        <p:spPr>
          <a:xfrm>
            <a:off x="5093311" y="2148372"/>
            <a:ext cx="60768" cy="62181"/>
          </a:xfrm>
          <a:prstGeom prst="ellipse">
            <a:avLst/>
          </a:prstGeom>
          <a:solidFill>
            <a:schemeClr val="tx1"/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0" name="Arc 79"/>
          <p:cNvSpPr/>
          <p:nvPr/>
        </p:nvSpPr>
        <p:spPr>
          <a:xfrm rot="8434837">
            <a:off x="5079146" y="2184221"/>
            <a:ext cx="403595" cy="297149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1" name="Arc 80"/>
          <p:cNvSpPr/>
          <p:nvPr/>
        </p:nvSpPr>
        <p:spPr>
          <a:xfrm rot="13957793">
            <a:off x="5059868" y="2126120"/>
            <a:ext cx="112802" cy="98186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31" name="Straight Connector 30"/>
          <p:cNvCxnSpPr/>
          <p:nvPr/>
        </p:nvCxnSpPr>
        <p:spPr>
          <a:xfrm flipH="1" flipV="1">
            <a:off x="5380717" y="2332366"/>
            <a:ext cx="14771" cy="412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 flipH="1" flipV="1">
            <a:off x="5383825" y="2301609"/>
            <a:ext cx="15146" cy="388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 flipH="1" flipV="1">
            <a:off x="5383826" y="2267745"/>
            <a:ext cx="16875" cy="412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 flipH="1" flipV="1">
            <a:off x="5338672" y="2422963"/>
            <a:ext cx="10309" cy="32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 flipH="1" flipV="1">
            <a:off x="5324285" y="2439895"/>
            <a:ext cx="10309" cy="32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 flipH="1" flipV="1">
            <a:off x="5307064" y="2448643"/>
            <a:ext cx="10309" cy="32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 flipH="1" flipV="1">
            <a:off x="5287302" y="2457391"/>
            <a:ext cx="10309" cy="32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 flipH="1" flipV="1">
            <a:off x="5265012" y="2468115"/>
            <a:ext cx="10309" cy="32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 flipH="1" flipV="1">
            <a:off x="5242447" y="2473207"/>
            <a:ext cx="10309" cy="32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 flipH="1" flipV="1">
            <a:off x="5220704" y="2474043"/>
            <a:ext cx="10309" cy="32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 flipH="1" flipV="1">
            <a:off x="5361977" y="2384306"/>
            <a:ext cx="15779" cy="422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 flipH="1" flipV="1">
            <a:off x="5349277" y="2402086"/>
            <a:ext cx="15779" cy="422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Arc 112"/>
          <p:cNvSpPr/>
          <p:nvPr/>
        </p:nvSpPr>
        <p:spPr>
          <a:xfrm rot="12233140">
            <a:off x="4896750" y="2116899"/>
            <a:ext cx="486244" cy="428255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4" name="Arc 113"/>
          <p:cNvSpPr/>
          <p:nvPr/>
        </p:nvSpPr>
        <p:spPr>
          <a:xfrm rot="7290506">
            <a:off x="4935858" y="2089066"/>
            <a:ext cx="463329" cy="472766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8" name="Arc 57"/>
          <p:cNvSpPr/>
          <p:nvPr/>
        </p:nvSpPr>
        <p:spPr>
          <a:xfrm rot="542202">
            <a:off x="4857617" y="2030030"/>
            <a:ext cx="587805" cy="624284"/>
          </a:xfrm>
          <a:prstGeom prst="arc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5" name="Arc 114"/>
          <p:cNvSpPr/>
          <p:nvPr/>
        </p:nvSpPr>
        <p:spPr>
          <a:xfrm rot="6057025">
            <a:off x="4842377" y="2009710"/>
            <a:ext cx="587805" cy="624284"/>
          </a:xfrm>
          <a:prstGeom prst="arc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16" name="Straight Connector 115"/>
          <p:cNvCxnSpPr/>
          <p:nvPr/>
        </p:nvCxnSpPr>
        <p:spPr>
          <a:xfrm flipH="1" flipV="1">
            <a:off x="5372137" y="2361446"/>
            <a:ext cx="15779" cy="422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Arc 116"/>
          <p:cNvSpPr/>
          <p:nvPr/>
        </p:nvSpPr>
        <p:spPr>
          <a:xfrm rot="11607613">
            <a:off x="4860157" y="1994470"/>
            <a:ext cx="587805" cy="624284"/>
          </a:xfrm>
          <a:prstGeom prst="arc">
            <a:avLst/>
          </a:prstGeom>
          <a:ln w="1270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8" name="Arc 117"/>
          <p:cNvSpPr/>
          <p:nvPr/>
        </p:nvSpPr>
        <p:spPr>
          <a:xfrm rot="16686003">
            <a:off x="4883017" y="1971610"/>
            <a:ext cx="587805" cy="624284"/>
          </a:xfrm>
          <a:prstGeom prst="arc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3" name="Isosceles Triangle 82"/>
          <p:cNvSpPr/>
          <p:nvPr/>
        </p:nvSpPr>
        <p:spPr>
          <a:xfrm rot="12818590">
            <a:off x="5345351" y="1691591"/>
            <a:ext cx="60749" cy="35871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20" name="Isosceles Triangle 119"/>
          <p:cNvSpPr/>
          <p:nvPr/>
        </p:nvSpPr>
        <p:spPr>
          <a:xfrm rot="9567011">
            <a:off x="5029690" y="1635174"/>
            <a:ext cx="64611" cy="356495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5" name="TextBox 84"/>
          <p:cNvSpPr txBox="1"/>
          <p:nvPr/>
        </p:nvSpPr>
        <p:spPr>
          <a:xfrm>
            <a:off x="4977063" y="2412301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5017149" y="245668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4859792" y="2239711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225280" y="244677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6082318" y="3946561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5050529" y="2413041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5007614" y="2155029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rapezoid 146"/>
          <p:cNvSpPr/>
          <p:nvPr/>
        </p:nvSpPr>
        <p:spPr>
          <a:xfrm rot="1822361">
            <a:off x="5537253" y="1391099"/>
            <a:ext cx="74417" cy="346785"/>
          </a:xfrm>
          <a:prstGeom prst="trapezoi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0" name="Trapezoid 149"/>
          <p:cNvSpPr/>
          <p:nvPr/>
        </p:nvSpPr>
        <p:spPr>
          <a:xfrm rot="20231256">
            <a:off x="4898145" y="1308386"/>
            <a:ext cx="72689" cy="346785"/>
          </a:xfrm>
          <a:prstGeom prst="trapezoi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1" name="Arc 150"/>
          <p:cNvSpPr/>
          <p:nvPr/>
        </p:nvSpPr>
        <p:spPr>
          <a:xfrm rot="1140273">
            <a:off x="5700270" y="3778434"/>
            <a:ext cx="491147" cy="493509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2" name="Arc 151"/>
          <p:cNvSpPr/>
          <p:nvPr/>
        </p:nvSpPr>
        <p:spPr>
          <a:xfrm rot="11365912">
            <a:off x="5269599" y="4047864"/>
            <a:ext cx="161953" cy="172902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3" name="Arc 152"/>
          <p:cNvSpPr/>
          <p:nvPr/>
        </p:nvSpPr>
        <p:spPr>
          <a:xfrm rot="6365790">
            <a:off x="5071295" y="3090645"/>
            <a:ext cx="722510" cy="1564762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60" name="Straight Connector 159"/>
          <p:cNvCxnSpPr/>
          <p:nvPr/>
        </p:nvCxnSpPr>
        <p:spPr>
          <a:xfrm flipH="1" flipV="1">
            <a:off x="5146036" y="2434822"/>
            <a:ext cx="18047" cy="586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/>
          <p:cNvCxnSpPr/>
          <p:nvPr/>
        </p:nvCxnSpPr>
        <p:spPr>
          <a:xfrm>
            <a:off x="5171384" y="2463497"/>
            <a:ext cx="9133" cy="344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Arc 170"/>
          <p:cNvSpPr/>
          <p:nvPr/>
        </p:nvSpPr>
        <p:spPr>
          <a:xfrm rot="6516463">
            <a:off x="5172508" y="3383435"/>
            <a:ext cx="479658" cy="1145745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2" name="Arc 171"/>
          <p:cNvSpPr/>
          <p:nvPr/>
        </p:nvSpPr>
        <p:spPr>
          <a:xfrm rot="11487292">
            <a:off x="5267007" y="4091280"/>
            <a:ext cx="238790" cy="96124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3" name="Arc 172"/>
          <p:cNvSpPr/>
          <p:nvPr/>
        </p:nvSpPr>
        <p:spPr>
          <a:xfrm rot="10306052">
            <a:off x="5210602" y="3914209"/>
            <a:ext cx="628663" cy="358137"/>
          </a:xfrm>
          <a:prstGeom prst="arc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5" name="Arc 174"/>
          <p:cNvSpPr/>
          <p:nvPr/>
        </p:nvSpPr>
        <p:spPr>
          <a:xfrm rot="16897735">
            <a:off x="5966471" y="3776230"/>
            <a:ext cx="97759" cy="128333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8" name="Arc 177"/>
          <p:cNvSpPr/>
          <p:nvPr/>
        </p:nvSpPr>
        <p:spPr>
          <a:xfrm rot="6431142">
            <a:off x="5219271" y="3471567"/>
            <a:ext cx="435538" cy="1015266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9" name="Arc 178"/>
          <p:cNvSpPr/>
          <p:nvPr/>
        </p:nvSpPr>
        <p:spPr>
          <a:xfrm rot="6064969">
            <a:off x="5520338" y="3821854"/>
            <a:ext cx="213499" cy="488824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0" name="Arc 179"/>
          <p:cNvSpPr/>
          <p:nvPr/>
        </p:nvSpPr>
        <p:spPr>
          <a:xfrm rot="1653697" flipH="1">
            <a:off x="5538219" y="4166016"/>
            <a:ext cx="89202" cy="109565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1" name="Arc 180"/>
          <p:cNvSpPr/>
          <p:nvPr/>
        </p:nvSpPr>
        <p:spPr>
          <a:xfrm rot="5400000">
            <a:off x="6018403" y="3804920"/>
            <a:ext cx="111967" cy="91996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2" name="Oval 181"/>
          <p:cNvSpPr/>
          <p:nvPr/>
        </p:nvSpPr>
        <p:spPr>
          <a:xfrm>
            <a:off x="5984262" y="3823430"/>
            <a:ext cx="78939" cy="78203"/>
          </a:xfrm>
          <a:prstGeom prst="ellipse">
            <a:avLst/>
          </a:prstGeom>
          <a:solidFill>
            <a:schemeClr val="tx1"/>
          </a:solidFill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3" name="Arc 182"/>
          <p:cNvSpPr/>
          <p:nvPr/>
        </p:nvSpPr>
        <p:spPr>
          <a:xfrm rot="12171633">
            <a:off x="5946811" y="3781150"/>
            <a:ext cx="97759" cy="128333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4" name="Arc 183"/>
          <p:cNvSpPr/>
          <p:nvPr/>
        </p:nvSpPr>
        <p:spPr>
          <a:xfrm rot="6777729">
            <a:off x="6048184" y="3830793"/>
            <a:ext cx="110049" cy="78262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5" name="Arc 184"/>
          <p:cNvSpPr/>
          <p:nvPr/>
        </p:nvSpPr>
        <p:spPr>
          <a:xfrm rot="783166">
            <a:off x="5939724" y="3925042"/>
            <a:ext cx="213277" cy="333681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7" name="Arc 186"/>
          <p:cNvSpPr/>
          <p:nvPr/>
        </p:nvSpPr>
        <p:spPr>
          <a:xfrm rot="6446132">
            <a:off x="5439935" y="3721348"/>
            <a:ext cx="308045" cy="653442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9" name="Oval 68"/>
          <p:cNvSpPr/>
          <p:nvPr/>
        </p:nvSpPr>
        <p:spPr>
          <a:xfrm rot="20650575">
            <a:off x="4975402" y="2250365"/>
            <a:ext cx="227962" cy="205504"/>
          </a:xfrm>
          <a:prstGeom prst="ellipse">
            <a:avLst/>
          </a:prstGeom>
          <a:solidFill>
            <a:schemeClr val="bg2">
              <a:lumMod val="9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8" name="Arc 187"/>
          <p:cNvSpPr/>
          <p:nvPr/>
        </p:nvSpPr>
        <p:spPr>
          <a:xfrm rot="13957793">
            <a:off x="5045001" y="2122399"/>
            <a:ext cx="91653" cy="87307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9" name="Arc 188"/>
          <p:cNvSpPr/>
          <p:nvPr/>
        </p:nvSpPr>
        <p:spPr>
          <a:xfrm rot="6040718">
            <a:off x="5241317" y="3331499"/>
            <a:ext cx="546884" cy="1300644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4" name="Oval 153"/>
          <p:cNvSpPr/>
          <p:nvPr/>
        </p:nvSpPr>
        <p:spPr>
          <a:xfrm rot="18948812">
            <a:off x="5845544" y="3907903"/>
            <a:ext cx="230621" cy="250234"/>
          </a:xfrm>
          <a:prstGeom prst="ellipse">
            <a:avLst/>
          </a:prstGeom>
          <a:solidFill>
            <a:schemeClr val="bg2">
              <a:lumMod val="9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192" name="Straight Connector 191"/>
          <p:cNvCxnSpPr/>
          <p:nvPr/>
        </p:nvCxnSpPr>
        <p:spPr>
          <a:xfrm>
            <a:off x="5903527" y="4166501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197"/>
          <p:cNvCxnSpPr/>
          <p:nvPr/>
        </p:nvCxnSpPr>
        <p:spPr>
          <a:xfrm>
            <a:off x="5878951" y="4183711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Straight Connector 198"/>
          <p:cNvCxnSpPr/>
          <p:nvPr/>
        </p:nvCxnSpPr>
        <p:spPr>
          <a:xfrm>
            <a:off x="5856825" y="4195997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199"/>
          <p:cNvCxnSpPr/>
          <p:nvPr/>
        </p:nvCxnSpPr>
        <p:spPr>
          <a:xfrm>
            <a:off x="5832245" y="4205829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/>
          <p:cNvCxnSpPr/>
          <p:nvPr/>
        </p:nvCxnSpPr>
        <p:spPr>
          <a:xfrm>
            <a:off x="5807665" y="4213203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Connector 201"/>
          <p:cNvCxnSpPr/>
          <p:nvPr/>
        </p:nvCxnSpPr>
        <p:spPr>
          <a:xfrm>
            <a:off x="5780627" y="4220577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Straight Connector 202"/>
          <p:cNvCxnSpPr/>
          <p:nvPr/>
        </p:nvCxnSpPr>
        <p:spPr>
          <a:xfrm>
            <a:off x="5748673" y="4225493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Straight Connector 203"/>
          <p:cNvCxnSpPr/>
          <p:nvPr/>
        </p:nvCxnSpPr>
        <p:spPr>
          <a:xfrm>
            <a:off x="5719175" y="4230409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Connector 204"/>
          <p:cNvCxnSpPr/>
          <p:nvPr/>
        </p:nvCxnSpPr>
        <p:spPr>
          <a:xfrm>
            <a:off x="5689681" y="4232867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Straight Connector 205"/>
          <p:cNvCxnSpPr/>
          <p:nvPr/>
        </p:nvCxnSpPr>
        <p:spPr>
          <a:xfrm>
            <a:off x="5660185" y="4232867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Straight Connector 206"/>
          <p:cNvCxnSpPr/>
          <p:nvPr/>
        </p:nvCxnSpPr>
        <p:spPr>
          <a:xfrm>
            <a:off x="5630679" y="4232867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Connector 207"/>
          <p:cNvCxnSpPr/>
          <p:nvPr/>
        </p:nvCxnSpPr>
        <p:spPr>
          <a:xfrm>
            <a:off x="5601193" y="4230409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Straight Connector 208"/>
          <p:cNvCxnSpPr/>
          <p:nvPr/>
        </p:nvCxnSpPr>
        <p:spPr>
          <a:xfrm>
            <a:off x="5574151" y="4227951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Straight Connector 209"/>
          <p:cNvCxnSpPr/>
          <p:nvPr/>
        </p:nvCxnSpPr>
        <p:spPr>
          <a:xfrm>
            <a:off x="5542187" y="4225493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Connector 210"/>
          <p:cNvCxnSpPr/>
          <p:nvPr/>
        </p:nvCxnSpPr>
        <p:spPr>
          <a:xfrm>
            <a:off x="5510247" y="4220577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/>
          <p:cNvCxnSpPr/>
          <p:nvPr/>
        </p:nvCxnSpPr>
        <p:spPr>
          <a:xfrm>
            <a:off x="5478288" y="4215661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Connector 212"/>
          <p:cNvCxnSpPr/>
          <p:nvPr/>
        </p:nvCxnSpPr>
        <p:spPr>
          <a:xfrm>
            <a:off x="5438956" y="4205829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Connector 213"/>
          <p:cNvCxnSpPr/>
          <p:nvPr/>
        </p:nvCxnSpPr>
        <p:spPr>
          <a:xfrm>
            <a:off x="5392250" y="4193539"/>
            <a:ext cx="29117" cy="183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5" name="Arc 214"/>
          <p:cNvSpPr/>
          <p:nvPr/>
        </p:nvSpPr>
        <p:spPr>
          <a:xfrm rot="10800000">
            <a:off x="5282037" y="4026126"/>
            <a:ext cx="542013" cy="150126"/>
          </a:xfrm>
          <a:prstGeom prst="arc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16" name="Arc 215"/>
          <p:cNvSpPr/>
          <p:nvPr/>
        </p:nvSpPr>
        <p:spPr>
          <a:xfrm rot="15835113">
            <a:off x="5196901" y="4075845"/>
            <a:ext cx="146016" cy="112239"/>
          </a:xfrm>
          <a:prstGeom prst="arc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17" name="Arc 216"/>
          <p:cNvSpPr/>
          <p:nvPr/>
        </p:nvSpPr>
        <p:spPr>
          <a:xfrm>
            <a:off x="5219302" y="4059428"/>
            <a:ext cx="62769" cy="91366"/>
          </a:xfrm>
          <a:prstGeom prst="arc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24" name="TextBox 223"/>
          <p:cNvSpPr txBox="1"/>
          <p:nvPr/>
        </p:nvSpPr>
        <p:spPr>
          <a:xfrm>
            <a:off x="5591176" y="4190063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6016807" y="4088948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6010461" y="4120031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5982124" y="4096368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30"/>
          <p:cNvSpPr txBox="1"/>
          <p:nvPr/>
        </p:nvSpPr>
        <p:spPr>
          <a:xfrm>
            <a:off x="5978889" y="4134724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5943912" y="411008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/>
          <p:cNvSpPr txBox="1"/>
          <p:nvPr/>
        </p:nvSpPr>
        <p:spPr>
          <a:xfrm>
            <a:off x="5943313" y="4139317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/>
          <p:cNvSpPr txBox="1"/>
          <p:nvPr/>
        </p:nvSpPr>
        <p:spPr>
          <a:xfrm>
            <a:off x="5908329" y="4116633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234"/>
          <p:cNvSpPr txBox="1"/>
          <p:nvPr/>
        </p:nvSpPr>
        <p:spPr>
          <a:xfrm>
            <a:off x="5915238" y="4154409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5884450" y="4145097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TextBox 236"/>
          <p:cNvSpPr txBox="1"/>
          <p:nvPr/>
        </p:nvSpPr>
        <p:spPr>
          <a:xfrm>
            <a:off x="5861184" y="416936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TextBox 237"/>
          <p:cNvSpPr txBox="1"/>
          <p:nvPr/>
        </p:nvSpPr>
        <p:spPr>
          <a:xfrm>
            <a:off x="5822812" y="4169366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238"/>
          <p:cNvSpPr txBox="1"/>
          <p:nvPr/>
        </p:nvSpPr>
        <p:spPr>
          <a:xfrm>
            <a:off x="5787036" y="4185757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TextBox 239"/>
          <p:cNvSpPr txBox="1"/>
          <p:nvPr/>
        </p:nvSpPr>
        <p:spPr>
          <a:xfrm>
            <a:off x="5743406" y="4185577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240"/>
          <p:cNvSpPr txBox="1"/>
          <p:nvPr/>
        </p:nvSpPr>
        <p:spPr>
          <a:xfrm>
            <a:off x="5707016" y="4190064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5667507" y="4194371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TextBox 242"/>
          <p:cNvSpPr txBox="1"/>
          <p:nvPr/>
        </p:nvSpPr>
        <p:spPr>
          <a:xfrm>
            <a:off x="5629679" y="419361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TextBox 243"/>
          <p:cNvSpPr txBox="1"/>
          <p:nvPr/>
        </p:nvSpPr>
        <p:spPr>
          <a:xfrm>
            <a:off x="5553902" y="4186748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TextBox 244"/>
          <p:cNvSpPr txBox="1"/>
          <p:nvPr/>
        </p:nvSpPr>
        <p:spPr>
          <a:xfrm>
            <a:off x="5517323" y="4183685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TextBox 245"/>
          <p:cNvSpPr txBox="1"/>
          <p:nvPr/>
        </p:nvSpPr>
        <p:spPr>
          <a:xfrm>
            <a:off x="5478312" y="417693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5444016" y="4174292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5381580" y="4159393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TextBox 248"/>
          <p:cNvSpPr txBox="1"/>
          <p:nvPr/>
        </p:nvSpPr>
        <p:spPr>
          <a:xfrm>
            <a:off x="5319328" y="4142328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TextBox 249"/>
          <p:cNvSpPr txBox="1"/>
          <p:nvPr/>
        </p:nvSpPr>
        <p:spPr>
          <a:xfrm>
            <a:off x="6092143" y="3890853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TextBox 250"/>
          <p:cNvSpPr txBox="1"/>
          <p:nvPr/>
        </p:nvSpPr>
        <p:spPr>
          <a:xfrm>
            <a:off x="6122442" y="3925554"/>
            <a:ext cx="109749" cy="1692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I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IN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Isosceles Triangle 253"/>
          <p:cNvSpPr/>
          <p:nvPr/>
        </p:nvSpPr>
        <p:spPr>
          <a:xfrm rot="8563689">
            <a:off x="5760179" y="3637771"/>
            <a:ext cx="45719" cy="366761"/>
          </a:xfrm>
          <a:prstGeom prst="triangl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55" name="Rounded Rectangle 254"/>
          <p:cNvSpPr/>
          <p:nvPr/>
        </p:nvSpPr>
        <p:spPr>
          <a:xfrm rot="19289124">
            <a:off x="5512451" y="3303476"/>
            <a:ext cx="53367" cy="404220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56" name="Flowchart: Connector 255"/>
          <p:cNvSpPr/>
          <p:nvPr/>
        </p:nvSpPr>
        <p:spPr>
          <a:xfrm>
            <a:off x="5928038" y="4011316"/>
            <a:ext cx="45719" cy="45719"/>
          </a:xfrm>
          <a:prstGeom prst="flowChartConnector">
            <a:avLst/>
          </a:prstGeom>
          <a:solidFill>
            <a:schemeClr val="bg2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1" name="Oval 10"/>
          <p:cNvSpPr/>
          <p:nvPr/>
        </p:nvSpPr>
        <p:spPr>
          <a:xfrm>
            <a:off x="6409305" y="1364872"/>
            <a:ext cx="1459533" cy="68966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34" name="Straight Arrow Connector 33"/>
          <p:cNvCxnSpPr/>
          <p:nvPr/>
        </p:nvCxnSpPr>
        <p:spPr>
          <a:xfrm flipV="1">
            <a:off x="6950807" y="1689404"/>
            <a:ext cx="228895" cy="154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Freeform 46"/>
          <p:cNvSpPr/>
          <p:nvPr/>
        </p:nvSpPr>
        <p:spPr>
          <a:xfrm>
            <a:off x="7156329" y="1555522"/>
            <a:ext cx="330082" cy="42208"/>
          </a:xfrm>
          <a:custGeom>
            <a:avLst/>
            <a:gdLst>
              <a:gd name="connsiteX0" fmla="*/ 0 w 330082"/>
              <a:gd name="connsiteY0" fmla="*/ 24953 h 42208"/>
              <a:gd name="connsiteX1" fmla="*/ 97631 w 330082"/>
              <a:gd name="connsiteY1" fmla="*/ 1141 h 42208"/>
              <a:gd name="connsiteX2" fmla="*/ 150019 w 330082"/>
              <a:gd name="connsiteY2" fmla="*/ 3522 h 42208"/>
              <a:gd name="connsiteX3" fmla="*/ 150019 w 330082"/>
              <a:gd name="connsiteY3" fmla="*/ 3522 h 42208"/>
              <a:gd name="connsiteX4" fmla="*/ 300037 w 330082"/>
              <a:gd name="connsiteY4" fmla="*/ 41622 h 42208"/>
              <a:gd name="connsiteX5" fmla="*/ 328612 w 330082"/>
              <a:gd name="connsiteY5" fmla="*/ 27334 h 42208"/>
              <a:gd name="connsiteX6" fmla="*/ 326231 w 330082"/>
              <a:gd name="connsiteY6" fmla="*/ 36859 h 42208"/>
              <a:gd name="connsiteX7" fmla="*/ 326231 w 330082"/>
              <a:gd name="connsiteY7" fmla="*/ 36859 h 42208"/>
              <a:gd name="connsiteX8" fmla="*/ 328612 w 330082"/>
              <a:gd name="connsiteY8" fmla="*/ 27334 h 42208"/>
              <a:gd name="connsiteX9" fmla="*/ 328612 w 330082"/>
              <a:gd name="connsiteY9" fmla="*/ 27334 h 422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330082" h="42208">
                <a:moveTo>
                  <a:pt x="0" y="24953"/>
                </a:moveTo>
                <a:cubicBezTo>
                  <a:pt x="36314" y="14833"/>
                  <a:pt x="72628" y="4713"/>
                  <a:pt x="97631" y="1141"/>
                </a:cubicBezTo>
                <a:cubicBezTo>
                  <a:pt x="122634" y="-2431"/>
                  <a:pt x="150019" y="3522"/>
                  <a:pt x="150019" y="3522"/>
                </a:cubicBezTo>
                <a:lnTo>
                  <a:pt x="150019" y="3522"/>
                </a:lnTo>
                <a:cubicBezTo>
                  <a:pt x="175022" y="9872"/>
                  <a:pt x="270272" y="37653"/>
                  <a:pt x="300037" y="41622"/>
                </a:cubicBezTo>
                <a:cubicBezTo>
                  <a:pt x="329802" y="45591"/>
                  <a:pt x="324246" y="28128"/>
                  <a:pt x="328612" y="27334"/>
                </a:cubicBezTo>
                <a:cubicBezTo>
                  <a:pt x="332978" y="26540"/>
                  <a:pt x="326231" y="36859"/>
                  <a:pt x="326231" y="36859"/>
                </a:cubicBezTo>
                <a:lnTo>
                  <a:pt x="326231" y="36859"/>
                </a:lnTo>
                <a:lnTo>
                  <a:pt x="328612" y="27334"/>
                </a:lnTo>
                <a:lnTo>
                  <a:pt x="328612" y="27334"/>
                </a:lnTo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38" name="Freeform 337"/>
          <p:cNvSpPr/>
          <p:nvPr/>
        </p:nvSpPr>
        <p:spPr>
          <a:xfrm>
            <a:off x="7247591" y="1681970"/>
            <a:ext cx="330082" cy="42208"/>
          </a:xfrm>
          <a:custGeom>
            <a:avLst/>
            <a:gdLst>
              <a:gd name="connsiteX0" fmla="*/ 0 w 330082"/>
              <a:gd name="connsiteY0" fmla="*/ 24953 h 42208"/>
              <a:gd name="connsiteX1" fmla="*/ 97631 w 330082"/>
              <a:gd name="connsiteY1" fmla="*/ 1141 h 42208"/>
              <a:gd name="connsiteX2" fmla="*/ 150019 w 330082"/>
              <a:gd name="connsiteY2" fmla="*/ 3522 h 42208"/>
              <a:gd name="connsiteX3" fmla="*/ 150019 w 330082"/>
              <a:gd name="connsiteY3" fmla="*/ 3522 h 42208"/>
              <a:gd name="connsiteX4" fmla="*/ 300037 w 330082"/>
              <a:gd name="connsiteY4" fmla="*/ 41622 h 42208"/>
              <a:gd name="connsiteX5" fmla="*/ 328612 w 330082"/>
              <a:gd name="connsiteY5" fmla="*/ 27334 h 42208"/>
              <a:gd name="connsiteX6" fmla="*/ 326231 w 330082"/>
              <a:gd name="connsiteY6" fmla="*/ 36859 h 42208"/>
              <a:gd name="connsiteX7" fmla="*/ 326231 w 330082"/>
              <a:gd name="connsiteY7" fmla="*/ 36859 h 42208"/>
              <a:gd name="connsiteX8" fmla="*/ 328612 w 330082"/>
              <a:gd name="connsiteY8" fmla="*/ 27334 h 42208"/>
              <a:gd name="connsiteX9" fmla="*/ 328612 w 330082"/>
              <a:gd name="connsiteY9" fmla="*/ 27334 h 422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330082" h="42208">
                <a:moveTo>
                  <a:pt x="0" y="24953"/>
                </a:moveTo>
                <a:cubicBezTo>
                  <a:pt x="36314" y="14833"/>
                  <a:pt x="72628" y="4713"/>
                  <a:pt x="97631" y="1141"/>
                </a:cubicBezTo>
                <a:cubicBezTo>
                  <a:pt x="122634" y="-2431"/>
                  <a:pt x="150019" y="3522"/>
                  <a:pt x="150019" y="3522"/>
                </a:cubicBezTo>
                <a:lnTo>
                  <a:pt x="150019" y="3522"/>
                </a:lnTo>
                <a:cubicBezTo>
                  <a:pt x="175022" y="9872"/>
                  <a:pt x="270272" y="37653"/>
                  <a:pt x="300037" y="41622"/>
                </a:cubicBezTo>
                <a:cubicBezTo>
                  <a:pt x="329802" y="45591"/>
                  <a:pt x="324246" y="28128"/>
                  <a:pt x="328612" y="27334"/>
                </a:cubicBezTo>
                <a:cubicBezTo>
                  <a:pt x="332978" y="26540"/>
                  <a:pt x="326231" y="36859"/>
                  <a:pt x="326231" y="36859"/>
                </a:cubicBezTo>
                <a:lnTo>
                  <a:pt x="326231" y="36859"/>
                </a:lnTo>
                <a:lnTo>
                  <a:pt x="328612" y="27334"/>
                </a:lnTo>
                <a:lnTo>
                  <a:pt x="328612" y="27334"/>
                </a:lnTo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39" name="Freeform 338"/>
          <p:cNvSpPr/>
          <p:nvPr/>
        </p:nvSpPr>
        <p:spPr>
          <a:xfrm>
            <a:off x="7156950" y="1822474"/>
            <a:ext cx="330082" cy="42208"/>
          </a:xfrm>
          <a:custGeom>
            <a:avLst/>
            <a:gdLst>
              <a:gd name="connsiteX0" fmla="*/ 0 w 330082"/>
              <a:gd name="connsiteY0" fmla="*/ 24953 h 42208"/>
              <a:gd name="connsiteX1" fmla="*/ 97631 w 330082"/>
              <a:gd name="connsiteY1" fmla="*/ 1141 h 42208"/>
              <a:gd name="connsiteX2" fmla="*/ 150019 w 330082"/>
              <a:gd name="connsiteY2" fmla="*/ 3522 h 42208"/>
              <a:gd name="connsiteX3" fmla="*/ 150019 w 330082"/>
              <a:gd name="connsiteY3" fmla="*/ 3522 h 42208"/>
              <a:gd name="connsiteX4" fmla="*/ 300037 w 330082"/>
              <a:gd name="connsiteY4" fmla="*/ 41622 h 42208"/>
              <a:gd name="connsiteX5" fmla="*/ 328612 w 330082"/>
              <a:gd name="connsiteY5" fmla="*/ 27334 h 42208"/>
              <a:gd name="connsiteX6" fmla="*/ 326231 w 330082"/>
              <a:gd name="connsiteY6" fmla="*/ 36859 h 42208"/>
              <a:gd name="connsiteX7" fmla="*/ 326231 w 330082"/>
              <a:gd name="connsiteY7" fmla="*/ 36859 h 42208"/>
              <a:gd name="connsiteX8" fmla="*/ 328612 w 330082"/>
              <a:gd name="connsiteY8" fmla="*/ 27334 h 42208"/>
              <a:gd name="connsiteX9" fmla="*/ 328612 w 330082"/>
              <a:gd name="connsiteY9" fmla="*/ 27334 h 422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330082" h="42208">
                <a:moveTo>
                  <a:pt x="0" y="24953"/>
                </a:moveTo>
                <a:cubicBezTo>
                  <a:pt x="36314" y="14833"/>
                  <a:pt x="72628" y="4713"/>
                  <a:pt x="97631" y="1141"/>
                </a:cubicBezTo>
                <a:cubicBezTo>
                  <a:pt x="122634" y="-2431"/>
                  <a:pt x="150019" y="3522"/>
                  <a:pt x="150019" y="3522"/>
                </a:cubicBezTo>
                <a:lnTo>
                  <a:pt x="150019" y="3522"/>
                </a:lnTo>
                <a:cubicBezTo>
                  <a:pt x="175022" y="9872"/>
                  <a:pt x="270272" y="37653"/>
                  <a:pt x="300037" y="41622"/>
                </a:cubicBezTo>
                <a:cubicBezTo>
                  <a:pt x="329802" y="45591"/>
                  <a:pt x="324246" y="28128"/>
                  <a:pt x="328612" y="27334"/>
                </a:cubicBezTo>
                <a:cubicBezTo>
                  <a:pt x="332978" y="26540"/>
                  <a:pt x="326231" y="36859"/>
                  <a:pt x="326231" y="36859"/>
                </a:cubicBezTo>
                <a:lnTo>
                  <a:pt x="326231" y="36859"/>
                </a:lnTo>
                <a:lnTo>
                  <a:pt x="328612" y="27334"/>
                </a:lnTo>
                <a:lnTo>
                  <a:pt x="328612" y="27334"/>
                </a:lnTo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2" name="TextBox 51"/>
          <p:cNvSpPr txBox="1"/>
          <p:nvPr/>
        </p:nvSpPr>
        <p:spPr>
          <a:xfrm>
            <a:off x="7411872" y="1467606"/>
            <a:ext cx="5109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aaaa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339"/>
          <p:cNvSpPr txBox="1"/>
          <p:nvPr/>
        </p:nvSpPr>
        <p:spPr>
          <a:xfrm>
            <a:off x="7509456" y="1593645"/>
            <a:ext cx="47019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aaaa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TextBox 340"/>
          <p:cNvSpPr txBox="1"/>
          <p:nvPr/>
        </p:nvSpPr>
        <p:spPr>
          <a:xfrm>
            <a:off x="7409035" y="1734805"/>
            <a:ext cx="60597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aaa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ight Arrow 83"/>
          <p:cNvSpPr/>
          <p:nvPr/>
        </p:nvSpPr>
        <p:spPr>
          <a:xfrm rot="5400000">
            <a:off x="9238917" y="3054964"/>
            <a:ext cx="645246" cy="18366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42" name="TextBox 341"/>
          <p:cNvSpPr txBox="1"/>
          <p:nvPr/>
        </p:nvSpPr>
        <p:spPr>
          <a:xfrm>
            <a:off x="8772194" y="2392939"/>
            <a:ext cx="15822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NA synthesis </a:t>
            </a:r>
            <a:endParaRPr lang="en-IN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Oval 342"/>
          <p:cNvSpPr/>
          <p:nvPr/>
        </p:nvSpPr>
        <p:spPr>
          <a:xfrm>
            <a:off x="8828070" y="1576864"/>
            <a:ext cx="1459533" cy="68966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44" name="Freeform 343"/>
          <p:cNvSpPr/>
          <p:nvPr/>
        </p:nvSpPr>
        <p:spPr>
          <a:xfrm>
            <a:off x="8902543" y="1891330"/>
            <a:ext cx="330082" cy="42208"/>
          </a:xfrm>
          <a:custGeom>
            <a:avLst/>
            <a:gdLst>
              <a:gd name="connsiteX0" fmla="*/ 0 w 330082"/>
              <a:gd name="connsiteY0" fmla="*/ 24953 h 42208"/>
              <a:gd name="connsiteX1" fmla="*/ 97631 w 330082"/>
              <a:gd name="connsiteY1" fmla="*/ 1141 h 42208"/>
              <a:gd name="connsiteX2" fmla="*/ 150019 w 330082"/>
              <a:gd name="connsiteY2" fmla="*/ 3522 h 42208"/>
              <a:gd name="connsiteX3" fmla="*/ 150019 w 330082"/>
              <a:gd name="connsiteY3" fmla="*/ 3522 h 42208"/>
              <a:gd name="connsiteX4" fmla="*/ 300037 w 330082"/>
              <a:gd name="connsiteY4" fmla="*/ 41622 h 42208"/>
              <a:gd name="connsiteX5" fmla="*/ 328612 w 330082"/>
              <a:gd name="connsiteY5" fmla="*/ 27334 h 42208"/>
              <a:gd name="connsiteX6" fmla="*/ 326231 w 330082"/>
              <a:gd name="connsiteY6" fmla="*/ 36859 h 42208"/>
              <a:gd name="connsiteX7" fmla="*/ 326231 w 330082"/>
              <a:gd name="connsiteY7" fmla="*/ 36859 h 42208"/>
              <a:gd name="connsiteX8" fmla="*/ 328612 w 330082"/>
              <a:gd name="connsiteY8" fmla="*/ 27334 h 42208"/>
              <a:gd name="connsiteX9" fmla="*/ 328612 w 330082"/>
              <a:gd name="connsiteY9" fmla="*/ 27334 h 422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330082" h="42208">
                <a:moveTo>
                  <a:pt x="0" y="24953"/>
                </a:moveTo>
                <a:cubicBezTo>
                  <a:pt x="36314" y="14833"/>
                  <a:pt x="72628" y="4713"/>
                  <a:pt x="97631" y="1141"/>
                </a:cubicBezTo>
                <a:cubicBezTo>
                  <a:pt x="122634" y="-2431"/>
                  <a:pt x="150019" y="3522"/>
                  <a:pt x="150019" y="3522"/>
                </a:cubicBezTo>
                <a:lnTo>
                  <a:pt x="150019" y="3522"/>
                </a:lnTo>
                <a:cubicBezTo>
                  <a:pt x="175022" y="9872"/>
                  <a:pt x="270272" y="37653"/>
                  <a:pt x="300037" y="41622"/>
                </a:cubicBezTo>
                <a:cubicBezTo>
                  <a:pt x="329802" y="45591"/>
                  <a:pt x="324246" y="28128"/>
                  <a:pt x="328612" y="27334"/>
                </a:cubicBezTo>
                <a:cubicBezTo>
                  <a:pt x="332978" y="26540"/>
                  <a:pt x="326231" y="36859"/>
                  <a:pt x="326231" y="36859"/>
                </a:cubicBezTo>
                <a:lnTo>
                  <a:pt x="326231" y="36859"/>
                </a:lnTo>
                <a:lnTo>
                  <a:pt x="328612" y="27334"/>
                </a:lnTo>
                <a:lnTo>
                  <a:pt x="328612" y="27334"/>
                </a:lnTo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45" name="TextBox 344"/>
          <p:cNvSpPr txBox="1"/>
          <p:nvPr/>
        </p:nvSpPr>
        <p:spPr>
          <a:xfrm>
            <a:off x="9166964" y="1803414"/>
            <a:ext cx="4080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aa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6" name="Straight Arrow Connector 345"/>
          <p:cNvCxnSpPr/>
          <p:nvPr/>
        </p:nvCxnSpPr>
        <p:spPr>
          <a:xfrm flipV="1">
            <a:off x="9453410" y="1901374"/>
            <a:ext cx="228895" cy="154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 flipV="1">
            <a:off x="9149097" y="3786809"/>
            <a:ext cx="806471" cy="11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4" name="Straight Connector 353"/>
          <p:cNvCxnSpPr/>
          <p:nvPr/>
        </p:nvCxnSpPr>
        <p:spPr>
          <a:xfrm>
            <a:off x="9151583" y="3783118"/>
            <a:ext cx="394" cy="44204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Freeform 145"/>
          <p:cNvSpPr/>
          <p:nvPr/>
        </p:nvSpPr>
        <p:spPr>
          <a:xfrm>
            <a:off x="9793216" y="1859755"/>
            <a:ext cx="427174" cy="90019"/>
          </a:xfrm>
          <a:custGeom>
            <a:avLst/>
            <a:gdLst>
              <a:gd name="connsiteX0" fmla="*/ 0 w 947420"/>
              <a:gd name="connsiteY0" fmla="*/ 144782 h 251512"/>
              <a:gd name="connsiteX1" fmla="*/ 78740 w 947420"/>
              <a:gd name="connsiteY1" fmla="*/ 246382 h 251512"/>
              <a:gd name="connsiteX2" fmla="*/ 228600 w 947420"/>
              <a:gd name="connsiteY2" fmla="*/ 2542 h 251512"/>
              <a:gd name="connsiteX3" fmla="*/ 386080 w 947420"/>
              <a:gd name="connsiteY3" fmla="*/ 251462 h 251512"/>
              <a:gd name="connsiteX4" fmla="*/ 541020 w 947420"/>
              <a:gd name="connsiteY4" fmla="*/ 2 h 251512"/>
              <a:gd name="connsiteX5" fmla="*/ 695960 w 947420"/>
              <a:gd name="connsiteY5" fmla="*/ 246382 h 251512"/>
              <a:gd name="connsiteX6" fmla="*/ 843280 w 947420"/>
              <a:gd name="connsiteY6" fmla="*/ 2542 h 251512"/>
              <a:gd name="connsiteX7" fmla="*/ 947420 w 947420"/>
              <a:gd name="connsiteY7" fmla="*/ 210822 h 251512"/>
              <a:gd name="connsiteX8" fmla="*/ 947420 w 947420"/>
              <a:gd name="connsiteY8" fmla="*/ 210822 h 2515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947420" h="251512">
                <a:moveTo>
                  <a:pt x="0" y="144782"/>
                </a:moveTo>
                <a:cubicBezTo>
                  <a:pt x="20320" y="207435"/>
                  <a:pt x="40640" y="270089"/>
                  <a:pt x="78740" y="246382"/>
                </a:cubicBezTo>
                <a:cubicBezTo>
                  <a:pt x="116840" y="222675"/>
                  <a:pt x="177377" y="1695"/>
                  <a:pt x="228600" y="2542"/>
                </a:cubicBezTo>
                <a:cubicBezTo>
                  <a:pt x="279823" y="3389"/>
                  <a:pt x="334010" y="251885"/>
                  <a:pt x="386080" y="251462"/>
                </a:cubicBezTo>
                <a:cubicBezTo>
                  <a:pt x="438150" y="251039"/>
                  <a:pt x="489373" y="849"/>
                  <a:pt x="541020" y="2"/>
                </a:cubicBezTo>
                <a:cubicBezTo>
                  <a:pt x="592667" y="-845"/>
                  <a:pt x="645583" y="245959"/>
                  <a:pt x="695960" y="246382"/>
                </a:cubicBezTo>
                <a:cubicBezTo>
                  <a:pt x="746337" y="246805"/>
                  <a:pt x="801370" y="8469"/>
                  <a:pt x="843280" y="2542"/>
                </a:cubicBezTo>
                <a:cubicBezTo>
                  <a:pt x="885190" y="-3385"/>
                  <a:pt x="947420" y="210822"/>
                  <a:pt x="947420" y="210822"/>
                </a:cubicBezTo>
                <a:lnTo>
                  <a:pt x="947420" y="210822"/>
                </a:lnTo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6" name="Freeform 155"/>
          <p:cNvSpPr/>
          <p:nvPr/>
        </p:nvSpPr>
        <p:spPr>
          <a:xfrm>
            <a:off x="9155832" y="3802230"/>
            <a:ext cx="619760" cy="405974"/>
          </a:xfrm>
          <a:custGeom>
            <a:avLst/>
            <a:gdLst>
              <a:gd name="connsiteX0" fmla="*/ 0 w 1092200"/>
              <a:gd name="connsiteY0" fmla="*/ 562611 h 562611"/>
              <a:gd name="connsiteX1" fmla="*/ 154940 w 1092200"/>
              <a:gd name="connsiteY1" fmla="*/ 562611 h 562611"/>
              <a:gd name="connsiteX2" fmla="*/ 154940 w 1092200"/>
              <a:gd name="connsiteY2" fmla="*/ 562611 h 562611"/>
              <a:gd name="connsiteX3" fmla="*/ 464820 w 1092200"/>
              <a:gd name="connsiteY3" fmla="*/ 77471 h 562611"/>
              <a:gd name="connsiteX4" fmla="*/ 1092200 w 1092200"/>
              <a:gd name="connsiteY4" fmla="*/ 1271 h 562611"/>
              <a:gd name="connsiteX5" fmla="*/ 1092200 w 1092200"/>
              <a:gd name="connsiteY5" fmla="*/ 1271 h 5626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92200" h="562611">
                <a:moveTo>
                  <a:pt x="0" y="562611"/>
                </a:moveTo>
                <a:lnTo>
                  <a:pt x="154940" y="562611"/>
                </a:lnTo>
                <a:lnTo>
                  <a:pt x="154940" y="562611"/>
                </a:lnTo>
                <a:cubicBezTo>
                  <a:pt x="206587" y="481755"/>
                  <a:pt x="308610" y="171028"/>
                  <a:pt x="464820" y="77471"/>
                </a:cubicBezTo>
                <a:cubicBezTo>
                  <a:pt x="621030" y="-16086"/>
                  <a:pt x="1092200" y="1271"/>
                  <a:pt x="1092200" y="1271"/>
                </a:cubicBezTo>
                <a:lnTo>
                  <a:pt x="1092200" y="1271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55" name="Freeform 354"/>
          <p:cNvSpPr/>
          <p:nvPr/>
        </p:nvSpPr>
        <p:spPr>
          <a:xfrm>
            <a:off x="9212029" y="3802230"/>
            <a:ext cx="619760" cy="405974"/>
          </a:xfrm>
          <a:custGeom>
            <a:avLst/>
            <a:gdLst>
              <a:gd name="connsiteX0" fmla="*/ 0 w 1092200"/>
              <a:gd name="connsiteY0" fmla="*/ 562611 h 562611"/>
              <a:gd name="connsiteX1" fmla="*/ 154940 w 1092200"/>
              <a:gd name="connsiteY1" fmla="*/ 562611 h 562611"/>
              <a:gd name="connsiteX2" fmla="*/ 154940 w 1092200"/>
              <a:gd name="connsiteY2" fmla="*/ 562611 h 562611"/>
              <a:gd name="connsiteX3" fmla="*/ 464820 w 1092200"/>
              <a:gd name="connsiteY3" fmla="*/ 77471 h 562611"/>
              <a:gd name="connsiteX4" fmla="*/ 1092200 w 1092200"/>
              <a:gd name="connsiteY4" fmla="*/ 1271 h 562611"/>
              <a:gd name="connsiteX5" fmla="*/ 1092200 w 1092200"/>
              <a:gd name="connsiteY5" fmla="*/ 1271 h 5626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92200" h="562611">
                <a:moveTo>
                  <a:pt x="0" y="562611"/>
                </a:moveTo>
                <a:lnTo>
                  <a:pt x="154940" y="562611"/>
                </a:lnTo>
                <a:lnTo>
                  <a:pt x="154940" y="562611"/>
                </a:lnTo>
                <a:cubicBezTo>
                  <a:pt x="206587" y="481755"/>
                  <a:pt x="308610" y="171028"/>
                  <a:pt x="464820" y="77471"/>
                </a:cubicBezTo>
                <a:cubicBezTo>
                  <a:pt x="621030" y="-16086"/>
                  <a:pt x="1092200" y="1271"/>
                  <a:pt x="1092200" y="1271"/>
                </a:cubicBezTo>
                <a:lnTo>
                  <a:pt x="1092200" y="1271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56" name="Freeform 355"/>
          <p:cNvSpPr/>
          <p:nvPr/>
        </p:nvSpPr>
        <p:spPr>
          <a:xfrm>
            <a:off x="9268226" y="3802230"/>
            <a:ext cx="619760" cy="405974"/>
          </a:xfrm>
          <a:custGeom>
            <a:avLst/>
            <a:gdLst>
              <a:gd name="connsiteX0" fmla="*/ 0 w 1092200"/>
              <a:gd name="connsiteY0" fmla="*/ 562611 h 562611"/>
              <a:gd name="connsiteX1" fmla="*/ 154940 w 1092200"/>
              <a:gd name="connsiteY1" fmla="*/ 562611 h 562611"/>
              <a:gd name="connsiteX2" fmla="*/ 154940 w 1092200"/>
              <a:gd name="connsiteY2" fmla="*/ 562611 h 562611"/>
              <a:gd name="connsiteX3" fmla="*/ 464820 w 1092200"/>
              <a:gd name="connsiteY3" fmla="*/ 77471 h 562611"/>
              <a:gd name="connsiteX4" fmla="*/ 1092200 w 1092200"/>
              <a:gd name="connsiteY4" fmla="*/ 1271 h 562611"/>
              <a:gd name="connsiteX5" fmla="*/ 1092200 w 1092200"/>
              <a:gd name="connsiteY5" fmla="*/ 1271 h 5626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92200" h="562611">
                <a:moveTo>
                  <a:pt x="0" y="562611"/>
                </a:moveTo>
                <a:lnTo>
                  <a:pt x="154940" y="562611"/>
                </a:lnTo>
                <a:lnTo>
                  <a:pt x="154940" y="562611"/>
                </a:lnTo>
                <a:cubicBezTo>
                  <a:pt x="206587" y="481755"/>
                  <a:pt x="308610" y="171028"/>
                  <a:pt x="464820" y="77471"/>
                </a:cubicBezTo>
                <a:cubicBezTo>
                  <a:pt x="621030" y="-16086"/>
                  <a:pt x="1092200" y="1271"/>
                  <a:pt x="1092200" y="1271"/>
                </a:cubicBezTo>
                <a:lnTo>
                  <a:pt x="1092200" y="1271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57" name="Freeform 356"/>
          <p:cNvSpPr/>
          <p:nvPr/>
        </p:nvSpPr>
        <p:spPr>
          <a:xfrm>
            <a:off x="9326646" y="3802230"/>
            <a:ext cx="619760" cy="405974"/>
          </a:xfrm>
          <a:custGeom>
            <a:avLst/>
            <a:gdLst>
              <a:gd name="connsiteX0" fmla="*/ 0 w 1092200"/>
              <a:gd name="connsiteY0" fmla="*/ 562611 h 562611"/>
              <a:gd name="connsiteX1" fmla="*/ 154940 w 1092200"/>
              <a:gd name="connsiteY1" fmla="*/ 562611 h 562611"/>
              <a:gd name="connsiteX2" fmla="*/ 154940 w 1092200"/>
              <a:gd name="connsiteY2" fmla="*/ 562611 h 562611"/>
              <a:gd name="connsiteX3" fmla="*/ 464820 w 1092200"/>
              <a:gd name="connsiteY3" fmla="*/ 77471 h 562611"/>
              <a:gd name="connsiteX4" fmla="*/ 1092200 w 1092200"/>
              <a:gd name="connsiteY4" fmla="*/ 1271 h 562611"/>
              <a:gd name="connsiteX5" fmla="*/ 1092200 w 1092200"/>
              <a:gd name="connsiteY5" fmla="*/ 1271 h 5626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92200" h="562611">
                <a:moveTo>
                  <a:pt x="0" y="562611"/>
                </a:moveTo>
                <a:lnTo>
                  <a:pt x="154940" y="562611"/>
                </a:lnTo>
                <a:lnTo>
                  <a:pt x="154940" y="562611"/>
                </a:lnTo>
                <a:cubicBezTo>
                  <a:pt x="206587" y="481755"/>
                  <a:pt x="308610" y="171028"/>
                  <a:pt x="464820" y="77471"/>
                </a:cubicBezTo>
                <a:cubicBezTo>
                  <a:pt x="621030" y="-16086"/>
                  <a:pt x="1092200" y="1271"/>
                  <a:pt x="1092200" y="1271"/>
                </a:cubicBezTo>
                <a:lnTo>
                  <a:pt x="1092200" y="1271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58" name="Oval 357"/>
          <p:cNvSpPr/>
          <p:nvPr/>
        </p:nvSpPr>
        <p:spPr>
          <a:xfrm>
            <a:off x="8835923" y="3661173"/>
            <a:ext cx="1459533" cy="68966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347" name="Straight Connector 346"/>
          <p:cNvCxnSpPr/>
          <p:nvPr/>
        </p:nvCxnSpPr>
        <p:spPr>
          <a:xfrm>
            <a:off x="9147192" y="4221433"/>
            <a:ext cx="814053" cy="11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TextBox 358"/>
          <p:cNvSpPr txBox="1"/>
          <p:nvPr/>
        </p:nvSpPr>
        <p:spPr>
          <a:xfrm>
            <a:off x="8734197" y="4472615"/>
            <a:ext cx="15822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PCR </a:t>
            </a:r>
            <a:endParaRPr lang="en-IN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Bent-Up Arrow 359"/>
          <p:cNvSpPr/>
          <p:nvPr/>
        </p:nvSpPr>
        <p:spPr>
          <a:xfrm flipV="1">
            <a:off x="8108175" y="1094654"/>
            <a:ext cx="1524558" cy="341887"/>
          </a:xfrm>
          <a:prstGeom prst="bentUp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63" name="Right Bracket 362"/>
          <p:cNvSpPr/>
          <p:nvPr/>
        </p:nvSpPr>
        <p:spPr>
          <a:xfrm rot="5400000">
            <a:off x="4753123" y="1684222"/>
            <a:ext cx="770361" cy="117475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64" name="Right Bracket 363"/>
          <p:cNvSpPr/>
          <p:nvPr/>
        </p:nvSpPr>
        <p:spPr>
          <a:xfrm rot="5400000">
            <a:off x="2330253" y="1684959"/>
            <a:ext cx="771835" cy="117475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65" name="Right Bracket 364"/>
          <p:cNvSpPr/>
          <p:nvPr/>
        </p:nvSpPr>
        <p:spPr>
          <a:xfrm rot="5400000">
            <a:off x="2523337" y="3448614"/>
            <a:ext cx="779114" cy="117475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66" name="Right Bracket 365"/>
          <p:cNvSpPr/>
          <p:nvPr/>
        </p:nvSpPr>
        <p:spPr>
          <a:xfrm rot="5400000">
            <a:off x="5334954" y="2953266"/>
            <a:ext cx="779456" cy="2165792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379" name="Straight Connector 378"/>
          <p:cNvCxnSpPr/>
          <p:nvPr/>
        </p:nvCxnSpPr>
        <p:spPr>
          <a:xfrm>
            <a:off x="2325516" y="3698824"/>
            <a:ext cx="1174756" cy="0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2" name="Straight Connector 381"/>
          <p:cNvCxnSpPr/>
          <p:nvPr/>
        </p:nvCxnSpPr>
        <p:spPr>
          <a:xfrm>
            <a:off x="2128866" y="1944311"/>
            <a:ext cx="1174756" cy="0"/>
          </a:xfrm>
          <a:prstGeom prst="line">
            <a:avLst/>
          </a:prstGeom>
          <a:ln>
            <a:solidFill>
              <a:schemeClr val="bg2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4" name="Rectangle 383"/>
          <p:cNvSpPr/>
          <p:nvPr/>
        </p:nvSpPr>
        <p:spPr>
          <a:xfrm>
            <a:off x="1910675" y="870010"/>
            <a:ext cx="8529465" cy="400383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388" name="Straight Connector 387"/>
          <p:cNvCxnSpPr/>
          <p:nvPr/>
        </p:nvCxnSpPr>
        <p:spPr>
          <a:xfrm flipH="1">
            <a:off x="5133904" y="2741405"/>
            <a:ext cx="1" cy="297186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9" name="Straight Connector 388"/>
          <p:cNvCxnSpPr/>
          <p:nvPr/>
        </p:nvCxnSpPr>
        <p:spPr>
          <a:xfrm flipH="1">
            <a:off x="6052340" y="2741401"/>
            <a:ext cx="1" cy="297186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0" name="Straight Connector 389"/>
          <p:cNvCxnSpPr/>
          <p:nvPr/>
        </p:nvCxnSpPr>
        <p:spPr>
          <a:xfrm flipH="1">
            <a:off x="6509549" y="2741390"/>
            <a:ext cx="1" cy="297186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1" name="Straight Connector 390"/>
          <p:cNvCxnSpPr/>
          <p:nvPr/>
        </p:nvCxnSpPr>
        <p:spPr>
          <a:xfrm flipH="1">
            <a:off x="8246125" y="2741389"/>
            <a:ext cx="1" cy="297186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2" name="Straight Connector 391"/>
          <p:cNvCxnSpPr/>
          <p:nvPr/>
        </p:nvCxnSpPr>
        <p:spPr>
          <a:xfrm flipV="1">
            <a:off x="5737444" y="3102713"/>
            <a:ext cx="1079" cy="314859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6" name="Straight Connector 395"/>
          <p:cNvCxnSpPr/>
          <p:nvPr/>
        </p:nvCxnSpPr>
        <p:spPr>
          <a:xfrm flipV="1">
            <a:off x="2901982" y="3102699"/>
            <a:ext cx="1079" cy="314859"/>
          </a:xfrm>
          <a:prstGeom prst="line">
            <a:avLst/>
          </a:prstGeom>
          <a:ln w="1905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2" name="Straight Connector 351"/>
          <p:cNvCxnSpPr/>
          <p:nvPr/>
        </p:nvCxnSpPr>
        <p:spPr>
          <a:xfrm>
            <a:off x="9951758" y="3786835"/>
            <a:ext cx="5677" cy="43459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Straight Connector 267"/>
          <p:cNvCxnSpPr/>
          <p:nvPr/>
        </p:nvCxnSpPr>
        <p:spPr>
          <a:xfrm flipH="1" flipV="1">
            <a:off x="5196650" y="2470375"/>
            <a:ext cx="10309" cy="32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TextBox 256"/>
          <p:cNvSpPr txBox="1"/>
          <p:nvPr/>
        </p:nvSpPr>
        <p:spPr>
          <a:xfrm>
            <a:off x="9663535" y="1776799"/>
            <a:ext cx="4080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9369922" y="1748512"/>
            <a:ext cx="3411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lang="en-IN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61675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38</TotalTime>
  <Words>220</Words>
  <Application>Microsoft Office PowerPoint</Application>
  <PresentationFormat>Widescreen</PresentationFormat>
  <Paragraphs>8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nal results</dc:title>
  <dc:creator>Abhishikta Basu</dc:creator>
  <cp:lastModifiedBy>Abhishikta Basu</cp:lastModifiedBy>
  <cp:revision>1018</cp:revision>
  <cp:lastPrinted>2019-02-25T07:19:18Z</cp:lastPrinted>
  <dcterms:created xsi:type="dcterms:W3CDTF">2018-11-09T05:24:25Z</dcterms:created>
  <dcterms:modified xsi:type="dcterms:W3CDTF">2019-12-23T06:54:51Z</dcterms:modified>
</cp:coreProperties>
</file>